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2"/>
  </p:notesMasterIdLst>
  <p:sldIdLst>
    <p:sldId id="283" r:id="rId2"/>
    <p:sldId id="285" r:id="rId3"/>
    <p:sldId id="280" r:id="rId4"/>
    <p:sldId id="271" r:id="rId5"/>
    <p:sldId id="279" r:id="rId6"/>
    <p:sldId id="282" r:id="rId7"/>
    <p:sldId id="286" r:id="rId8"/>
    <p:sldId id="284" r:id="rId9"/>
    <p:sldId id="287" r:id="rId10"/>
    <p:sldId id="288" r:id="rId11"/>
  </p:sldIdLst>
  <p:sldSz cx="6858000" cy="9144000" type="letter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E1FC45E-5279-4D42-BD20-D3C4B0717391}" v="7" dt="2023-04-24T07:36:40.00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82" autoAdjust="0"/>
    <p:restoredTop sz="96353" autoAdjust="0"/>
  </p:normalViewPr>
  <p:slideViewPr>
    <p:cSldViewPr snapToGrid="0">
      <p:cViewPr varScale="1">
        <p:scale>
          <a:sx n="83" d="100"/>
          <a:sy n="83" d="100"/>
        </p:scale>
        <p:origin x="3612" y="102"/>
      </p:cViewPr>
      <p:guideLst/>
    </p:cSldViewPr>
  </p:slideViewPr>
  <p:notesTextViewPr>
    <p:cViewPr>
      <p:scale>
        <a:sx n="50" d="100"/>
        <a:sy n="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장영훈" userId="cf5095d1-1c10-4b0e-b263-7acd6c30bdc2" providerId="ADAL" clId="{5E1FC45E-5279-4D42-BD20-D3C4B0717391}"/>
    <pc:docChg chg="undo custSel addSld modSld">
      <pc:chgData name="장영훈" userId="cf5095d1-1c10-4b0e-b263-7acd6c30bdc2" providerId="ADAL" clId="{5E1FC45E-5279-4D42-BD20-D3C4B0717391}" dt="2023-04-24T07:37:22.698" v="683"/>
      <pc:docMkLst>
        <pc:docMk/>
      </pc:docMkLst>
      <pc:sldChg chg="modSp mod">
        <pc:chgData name="장영훈" userId="cf5095d1-1c10-4b0e-b263-7acd6c30bdc2" providerId="ADAL" clId="{5E1FC45E-5279-4D42-BD20-D3C4B0717391}" dt="2023-04-24T06:11:18.509" v="71" actId="113"/>
        <pc:sldMkLst>
          <pc:docMk/>
          <pc:sldMk cId="709331740" sldId="271"/>
        </pc:sldMkLst>
        <pc:spChg chg="mod">
          <ac:chgData name="장영훈" userId="cf5095d1-1c10-4b0e-b263-7acd6c30bdc2" providerId="ADAL" clId="{5E1FC45E-5279-4D42-BD20-D3C4B0717391}" dt="2023-04-24T06:11:18.509" v="71" actId="113"/>
          <ac:spMkLst>
            <pc:docMk/>
            <pc:sldMk cId="709331740" sldId="271"/>
            <ac:spMk id="7" creationId="{F8B46C79-0A28-B897-0B9E-D194EEB6CF0F}"/>
          </ac:spMkLst>
        </pc:spChg>
      </pc:sldChg>
      <pc:sldChg chg="modSp mod">
        <pc:chgData name="장영훈" userId="cf5095d1-1c10-4b0e-b263-7acd6c30bdc2" providerId="ADAL" clId="{5E1FC45E-5279-4D42-BD20-D3C4B0717391}" dt="2023-04-24T06:13:06.240" v="419" actId="1035"/>
        <pc:sldMkLst>
          <pc:docMk/>
          <pc:sldMk cId="1785452891" sldId="279"/>
        </pc:sldMkLst>
        <pc:spChg chg="mod">
          <ac:chgData name="장영훈" userId="cf5095d1-1c10-4b0e-b263-7acd6c30bdc2" providerId="ADAL" clId="{5E1FC45E-5279-4D42-BD20-D3C4B0717391}" dt="2023-04-24T06:11:34.848" v="79"/>
          <ac:spMkLst>
            <pc:docMk/>
            <pc:sldMk cId="1785452891" sldId="279"/>
            <ac:spMk id="2" creationId="{61B03D1B-CB7E-BC94-FD1C-CD383847AD2B}"/>
          </ac:spMkLst>
        </pc:spChg>
        <pc:spChg chg="mod">
          <ac:chgData name="장영훈" userId="cf5095d1-1c10-4b0e-b263-7acd6c30bdc2" providerId="ADAL" clId="{5E1FC45E-5279-4D42-BD20-D3C4B0717391}" dt="2023-04-24T06:13:06.240" v="419" actId="1035"/>
          <ac:spMkLst>
            <pc:docMk/>
            <pc:sldMk cId="1785452891" sldId="279"/>
            <ac:spMk id="3" creationId="{F6D670A5-8FBD-F142-2637-2E66B2A1CA60}"/>
          </ac:spMkLst>
        </pc:spChg>
        <pc:spChg chg="mod">
          <ac:chgData name="장영훈" userId="cf5095d1-1c10-4b0e-b263-7acd6c30bdc2" providerId="ADAL" clId="{5E1FC45E-5279-4D42-BD20-D3C4B0717391}" dt="2023-04-24T06:13:06.240" v="419" actId="1035"/>
          <ac:spMkLst>
            <pc:docMk/>
            <pc:sldMk cId="1785452891" sldId="279"/>
            <ac:spMk id="4" creationId="{E7E0C368-F9E9-CB6B-36B8-EDCA5AFCC295}"/>
          </ac:spMkLst>
        </pc:spChg>
        <pc:spChg chg="mod">
          <ac:chgData name="장영훈" userId="cf5095d1-1c10-4b0e-b263-7acd6c30bdc2" providerId="ADAL" clId="{5E1FC45E-5279-4D42-BD20-D3C4B0717391}" dt="2023-04-24T06:13:06.240" v="419" actId="1035"/>
          <ac:spMkLst>
            <pc:docMk/>
            <pc:sldMk cId="1785452891" sldId="279"/>
            <ac:spMk id="8" creationId="{443EB4BB-2DA9-38D4-8526-AE5D93C1BD84}"/>
          </ac:spMkLst>
        </pc:spChg>
        <pc:spChg chg="mod">
          <ac:chgData name="장영훈" userId="cf5095d1-1c10-4b0e-b263-7acd6c30bdc2" providerId="ADAL" clId="{5E1FC45E-5279-4D42-BD20-D3C4B0717391}" dt="2023-04-24T06:13:06.240" v="419" actId="1035"/>
          <ac:spMkLst>
            <pc:docMk/>
            <pc:sldMk cId="1785452891" sldId="279"/>
            <ac:spMk id="9" creationId="{1C1BDF77-3342-E5D0-59E9-CD31F13E80D9}"/>
          </ac:spMkLst>
        </pc:spChg>
        <pc:spChg chg="mod">
          <ac:chgData name="장영훈" userId="cf5095d1-1c10-4b0e-b263-7acd6c30bdc2" providerId="ADAL" clId="{5E1FC45E-5279-4D42-BD20-D3C4B0717391}" dt="2023-04-24T06:13:06.240" v="419" actId="1035"/>
          <ac:spMkLst>
            <pc:docMk/>
            <pc:sldMk cId="1785452891" sldId="279"/>
            <ac:spMk id="12" creationId="{AFD94552-1068-6D84-F7C3-044E584EEB26}"/>
          </ac:spMkLst>
        </pc:spChg>
        <pc:spChg chg="mod">
          <ac:chgData name="장영훈" userId="cf5095d1-1c10-4b0e-b263-7acd6c30bdc2" providerId="ADAL" clId="{5E1FC45E-5279-4D42-BD20-D3C4B0717391}" dt="2023-04-24T06:13:06.240" v="419" actId="1035"/>
          <ac:spMkLst>
            <pc:docMk/>
            <pc:sldMk cId="1785452891" sldId="279"/>
            <ac:spMk id="13" creationId="{976125D2-E30E-1CA1-D93B-DD1EE234CA47}"/>
          </ac:spMkLst>
        </pc:spChg>
        <pc:picChg chg="mod">
          <ac:chgData name="장영훈" userId="cf5095d1-1c10-4b0e-b263-7acd6c30bdc2" providerId="ADAL" clId="{5E1FC45E-5279-4D42-BD20-D3C4B0717391}" dt="2023-04-24T06:13:06.240" v="419" actId="1035"/>
          <ac:picMkLst>
            <pc:docMk/>
            <pc:sldMk cId="1785452891" sldId="279"/>
            <ac:picMk id="15" creationId="{22C20A50-F6B0-A165-ED12-B58A4BBE8BC5}"/>
          </ac:picMkLst>
        </pc:picChg>
        <pc:picChg chg="mod">
          <ac:chgData name="장영훈" userId="cf5095d1-1c10-4b0e-b263-7acd6c30bdc2" providerId="ADAL" clId="{5E1FC45E-5279-4D42-BD20-D3C4B0717391}" dt="2023-04-24T06:13:06.240" v="419" actId="1035"/>
          <ac:picMkLst>
            <pc:docMk/>
            <pc:sldMk cId="1785452891" sldId="279"/>
            <ac:picMk id="17" creationId="{763B301F-74D1-ED06-D5A0-21D38BED5186}"/>
          </ac:picMkLst>
        </pc:picChg>
        <pc:picChg chg="mod">
          <ac:chgData name="장영훈" userId="cf5095d1-1c10-4b0e-b263-7acd6c30bdc2" providerId="ADAL" clId="{5E1FC45E-5279-4D42-BD20-D3C4B0717391}" dt="2023-04-24T06:13:06.240" v="419" actId="1035"/>
          <ac:picMkLst>
            <pc:docMk/>
            <pc:sldMk cId="1785452891" sldId="279"/>
            <ac:picMk id="19" creationId="{693C5AED-154E-B9C9-E847-BAF4A5B9E9D5}"/>
          </ac:picMkLst>
        </pc:picChg>
        <pc:picChg chg="mod">
          <ac:chgData name="장영훈" userId="cf5095d1-1c10-4b0e-b263-7acd6c30bdc2" providerId="ADAL" clId="{5E1FC45E-5279-4D42-BD20-D3C4B0717391}" dt="2023-04-24T06:13:06.240" v="419" actId="1035"/>
          <ac:picMkLst>
            <pc:docMk/>
            <pc:sldMk cId="1785452891" sldId="279"/>
            <ac:picMk id="21" creationId="{45DA7BEF-D6B9-60F8-D59C-C417F6CC4F7F}"/>
          </ac:picMkLst>
        </pc:picChg>
      </pc:sldChg>
      <pc:sldChg chg="addSp delSp modSp mod">
        <pc:chgData name="장영훈" userId="cf5095d1-1c10-4b0e-b263-7acd6c30bdc2" providerId="ADAL" clId="{5E1FC45E-5279-4D42-BD20-D3C4B0717391}" dt="2023-04-24T06:10:53.529" v="64"/>
        <pc:sldMkLst>
          <pc:docMk/>
          <pc:sldMk cId="1506836051" sldId="280"/>
        </pc:sldMkLst>
        <pc:spChg chg="add mod">
          <ac:chgData name="장영훈" userId="cf5095d1-1c10-4b0e-b263-7acd6c30bdc2" providerId="ADAL" clId="{5E1FC45E-5279-4D42-BD20-D3C4B0717391}" dt="2023-04-24T06:10:53.529" v="64"/>
          <ac:spMkLst>
            <pc:docMk/>
            <pc:sldMk cId="1506836051" sldId="280"/>
            <ac:spMk id="3" creationId="{D9659F17-317B-02B9-E2A4-096C3F6F2BA4}"/>
          </ac:spMkLst>
        </pc:spChg>
        <pc:spChg chg="del">
          <ac:chgData name="장영훈" userId="cf5095d1-1c10-4b0e-b263-7acd6c30bdc2" providerId="ADAL" clId="{5E1FC45E-5279-4D42-BD20-D3C4B0717391}" dt="2023-04-24T06:10:38.674" v="58" actId="478"/>
          <ac:spMkLst>
            <pc:docMk/>
            <pc:sldMk cId="1506836051" sldId="280"/>
            <ac:spMk id="23" creationId="{753012DC-BC66-CF76-16D4-227DB923246A}"/>
          </ac:spMkLst>
        </pc:spChg>
      </pc:sldChg>
      <pc:sldChg chg="modSp mod">
        <pc:chgData name="장영훈" userId="cf5095d1-1c10-4b0e-b263-7acd6c30bdc2" providerId="ADAL" clId="{5E1FC45E-5279-4D42-BD20-D3C4B0717391}" dt="2023-04-24T06:12:16.165" v="181"/>
        <pc:sldMkLst>
          <pc:docMk/>
          <pc:sldMk cId="2442387714" sldId="282"/>
        </pc:sldMkLst>
        <pc:spChg chg="mod">
          <ac:chgData name="장영훈" userId="cf5095d1-1c10-4b0e-b263-7acd6c30bdc2" providerId="ADAL" clId="{5E1FC45E-5279-4D42-BD20-D3C4B0717391}" dt="2023-04-24T06:12:16.165" v="181"/>
          <ac:spMkLst>
            <pc:docMk/>
            <pc:sldMk cId="2442387714" sldId="282"/>
            <ac:spMk id="2" creationId="{908AD643-1FB1-895D-0E8A-7D4C7B31130A}"/>
          </ac:spMkLst>
        </pc:spChg>
        <pc:graphicFrameChg chg="mod">
          <ac:chgData name="장영훈" userId="cf5095d1-1c10-4b0e-b263-7acd6c30bdc2" providerId="ADAL" clId="{5E1FC45E-5279-4D42-BD20-D3C4B0717391}" dt="2023-04-24T06:11:52.258" v="111" actId="1035"/>
          <ac:graphicFrameMkLst>
            <pc:docMk/>
            <pc:sldMk cId="2442387714" sldId="282"/>
            <ac:graphicFrameMk id="4" creationId="{2023CAE9-892A-9ADC-E67C-0022E3DAF109}"/>
          </ac:graphicFrameMkLst>
        </pc:graphicFrameChg>
        <pc:graphicFrameChg chg="mod">
          <ac:chgData name="장영훈" userId="cf5095d1-1c10-4b0e-b263-7acd6c30bdc2" providerId="ADAL" clId="{5E1FC45E-5279-4D42-BD20-D3C4B0717391}" dt="2023-04-24T06:11:58.406" v="151" actId="1035"/>
          <ac:graphicFrameMkLst>
            <pc:docMk/>
            <pc:sldMk cId="2442387714" sldId="282"/>
            <ac:graphicFrameMk id="5" creationId="{98660AB6-A689-0804-9E48-B25F6901BB9F}"/>
          </ac:graphicFrameMkLst>
        </pc:graphicFrameChg>
      </pc:sldChg>
      <pc:sldChg chg="modSp mod">
        <pc:chgData name="장영훈" userId="cf5095d1-1c10-4b0e-b263-7acd6c30bdc2" providerId="ADAL" clId="{5E1FC45E-5279-4D42-BD20-D3C4B0717391}" dt="2023-04-24T06:09:59.461" v="5"/>
        <pc:sldMkLst>
          <pc:docMk/>
          <pc:sldMk cId="1359123044" sldId="283"/>
        </pc:sldMkLst>
        <pc:spChg chg="mod">
          <ac:chgData name="장영훈" userId="cf5095d1-1c10-4b0e-b263-7acd6c30bdc2" providerId="ADAL" clId="{5E1FC45E-5279-4D42-BD20-D3C4B0717391}" dt="2023-04-24T06:09:59.461" v="5"/>
          <ac:spMkLst>
            <pc:docMk/>
            <pc:sldMk cId="1359123044" sldId="283"/>
            <ac:spMk id="23" creationId="{753012DC-BC66-CF76-16D4-227DB923246A}"/>
          </ac:spMkLst>
        </pc:spChg>
      </pc:sldChg>
      <pc:sldChg chg="addSp delSp modSp mod">
        <pc:chgData name="장영훈" userId="cf5095d1-1c10-4b0e-b263-7acd6c30bdc2" providerId="ADAL" clId="{5E1FC45E-5279-4D42-BD20-D3C4B0717391}" dt="2023-04-24T06:17:58.405" v="502" actId="1076"/>
        <pc:sldMkLst>
          <pc:docMk/>
          <pc:sldMk cId="990490276" sldId="284"/>
        </pc:sldMkLst>
        <pc:spChg chg="mod">
          <ac:chgData name="장영훈" userId="cf5095d1-1c10-4b0e-b263-7acd6c30bdc2" providerId="ADAL" clId="{5E1FC45E-5279-4D42-BD20-D3C4B0717391}" dt="2023-04-24T06:17:52.332" v="501" actId="1076"/>
          <ac:spMkLst>
            <pc:docMk/>
            <pc:sldMk cId="990490276" sldId="284"/>
            <ac:spMk id="3" creationId="{ADE5A25D-87A5-C4F6-9051-89AEF995E827}"/>
          </ac:spMkLst>
        </pc:spChg>
        <pc:spChg chg="mod">
          <ac:chgData name="장영훈" userId="cf5095d1-1c10-4b0e-b263-7acd6c30bdc2" providerId="ADAL" clId="{5E1FC45E-5279-4D42-BD20-D3C4B0717391}" dt="2023-04-24T06:17:58.405" v="502" actId="1076"/>
          <ac:spMkLst>
            <pc:docMk/>
            <pc:sldMk cId="990490276" sldId="284"/>
            <ac:spMk id="4" creationId="{0EE33720-C4B9-4DDF-9227-C5B7AC746916}"/>
          </ac:spMkLst>
        </pc:spChg>
        <pc:spChg chg="mod">
          <ac:chgData name="장영훈" userId="cf5095d1-1c10-4b0e-b263-7acd6c30bdc2" providerId="ADAL" clId="{5E1FC45E-5279-4D42-BD20-D3C4B0717391}" dt="2023-04-24T06:17:58.405" v="502" actId="1076"/>
          <ac:spMkLst>
            <pc:docMk/>
            <pc:sldMk cId="990490276" sldId="284"/>
            <ac:spMk id="7" creationId="{D5FC179B-4280-6614-8D8F-D2DB4A938FEF}"/>
          </ac:spMkLst>
        </pc:spChg>
        <pc:spChg chg="mod">
          <ac:chgData name="장영훈" userId="cf5095d1-1c10-4b0e-b263-7acd6c30bdc2" providerId="ADAL" clId="{5E1FC45E-5279-4D42-BD20-D3C4B0717391}" dt="2023-04-24T06:17:58.405" v="502" actId="1076"/>
          <ac:spMkLst>
            <pc:docMk/>
            <pc:sldMk cId="990490276" sldId="284"/>
            <ac:spMk id="8" creationId="{8875B843-4411-2110-4781-79D88D47525F}"/>
          </ac:spMkLst>
        </pc:spChg>
        <pc:spChg chg="del">
          <ac:chgData name="장영훈" userId="cf5095d1-1c10-4b0e-b263-7acd6c30bdc2" providerId="ADAL" clId="{5E1FC45E-5279-4D42-BD20-D3C4B0717391}" dt="2023-04-24T06:17:36.450" v="499" actId="478"/>
          <ac:spMkLst>
            <pc:docMk/>
            <pc:sldMk cId="990490276" sldId="284"/>
            <ac:spMk id="9" creationId="{1D8411F5-3AAE-BD56-E61A-29E552DA00FC}"/>
          </ac:spMkLst>
        </pc:spChg>
        <pc:spChg chg="add mod">
          <ac:chgData name="장영훈" userId="cf5095d1-1c10-4b0e-b263-7acd6c30bdc2" providerId="ADAL" clId="{5E1FC45E-5279-4D42-BD20-D3C4B0717391}" dt="2023-04-24T06:17:31.609" v="498"/>
          <ac:spMkLst>
            <pc:docMk/>
            <pc:sldMk cId="990490276" sldId="284"/>
            <ac:spMk id="10" creationId="{17D673F5-8989-7E5A-08F6-59867C9103BC}"/>
          </ac:spMkLst>
        </pc:spChg>
        <pc:spChg chg="mod">
          <ac:chgData name="장영훈" userId="cf5095d1-1c10-4b0e-b263-7acd6c30bdc2" providerId="ADAL" clId="{5E1FC45E-5279-4D42-BD20-D3C4B0717391}" dt="2023-04-24T06:17:58.405" v="502" actId="1076"/>
          <ac:spMkLst>
            <pc:docMk/>
            <pc:sldMk cId="990490276" sldId="284"/>
            <ac:spMk id="11" creationId="{CEF33A5D-6267-69E9-B91C-362A5D6AC80B}"/>
          </ac:spMkLst>
        </pc:spChg>
        <pc:spChg chg="mod">
          <ac:chgData name="장영훈" userId="cf5095d1-1c10-4b0e-b263-7acd6c30bdc2" providerId="ADAL" clId="{5E1FC45E-5279-4D42-BD20-D3C4B0717391}" dt="2023-04-24T06:17:58.405" v="502" actId="1076"/>
          <ac:spMkLst>
            <pc:docMk/>
            <pc:sldMk cId="990490276" sldId="284"/>
            <ac:spMk id="13" creationId="{7A2A845D-31E8-FDC1-C174-A847D6182EA8}"/>
          </ac:spMkLst>
        </pc:spChg>
        <pc:spChg chg="mod">
          <ac:chgData name="장영훈" userId="cf5095d1-1c10-4b0e-b263-7acd6c30bdc2" providerId="ADAL" clId="{5E1FC45E-5279-4D42-BD20-D3C4B0717391}" dt="2023-04-24T06:17:58.405" v="502" actId="1076"/>
          <ac:spMkLst>
            <pc:docMk/>
            <pc:sldMk cId="990490276" sldId="284"/>
            <ac:spMk id="14" creationId="{850EAD0E-EDD2-1A34-2B14-3D293FEA8FFA}"/>
          </ac:spMkLst>
        </pc:spChg>
        <pc:spChg chg="mod">
          <ac:chgData name="장영훈" userId="cf5095d1-1c10-4b0e-b263-7acd6c30bdc2" providerId="ADAL" clId="{5E1FC45E-5279-4D42-BD20-D3C4B0717391}" dt="2023-04-24T06:17:58.405" v="502" actId="1076"/>
          <ac:spMkLst>
            <pc:docMk/>
            <pc:sldMk cId="990490276" sldId="284"/>
            <ac:spMk id="15" creationId="{2CCCDC97-6C85-2FE7-1437-B3513BE2F365}"/>
          </ac:spMkLst>
        </pc:spChg>
        <pc:spChg chg="mod">
          <ac:chgData name="장영훈" userId="cf5095d1-1c10-4b0e-b263-7acd6c30bdc2" providerId="ADAL" clId="{5E1FC45E-5279-4D42-BD20-D3C4B0717391}" dt="2023-04-24T06:17:58.405" v="502" actId="1076"/>
          <ac:spMkLst>
            <pc:docMk/>
            <pc:sldMk cId="990490276" sldId="284"/>
            <ac:spMk id="16" creationId="{4E7AA90A-DE4F-8028-EE1B-D6A085B664FD}"/>
          </ac:spMkLst>
        </pc:spChg>
        <pc:grpChg chg="mod">
          <ac:chgData name="장영훈" userId="cf5095d1-1c10-4b0e-b263-7acd6c30bdc2" providerId="ADAL" clId="{5E1FC45E-5279-4D42-BD20-D3C4B0717391}" dt="2023-04-24T06:17:58.405" v="502" actId="1076"/>
          <ac:grpSpMkLst>
            <pc:docMk/>
            <pc:sldMk cId="990490276" sldId="284"/>
            <ac:grpSpMk id="20" creationId="{1CAEB5E5-6771-028C-AE86-E3349762EBD3}"/>
          </ac:grpSpMkLst>
        </pc:grpChg>
        <pc:grpChg chg="mod">
          <ac:chgData name="장영훈" userId="cf5095d1-1c10-4b0e-b263-7acd6c30bdc2" providerId="ADAL" clId="{5E1FC45E-5279-4D42-BD20-D3C4B0717391}" dt="2023-04-24T06:17:58.405" v="502" actId="1076"/>
          <ac:grpSpMkLst>
            <pc:docMk/>
            <pc:sldMk cId="990490276" sldId="284"/>
            <ac:grpSpMk id="25" creationId="{C05A3C25-2734-81C0-AA38-B1338519D689}"/>
          </ac:grpSpMkLst>
        </pc:grpChg>
        <pc:grpChg chg="mod">
          <ac:chgData name="장영훈" userId="cf5095d1-1c10-4b0e-b263-7acd6c30bdc2" providerId="ADAL" clId="{5E1FC45E-5279-4D42-BD20-D3C4B0717391}" dt="2023-04-24T06:17:58.405" v="502" actId="1076"/>
          <ac:grpSpMkLst>
            <pc:docMk/>
            <pc:sldMk cId="990490276" sldId="284"/>
            <ac:grpSpMk id="28" creationId="{A65493D2-3E09-14D1-BC26-4BA1C1DAA7BF}"/>
          </ac:grpSpMkLst>
        </pc:grpChg>
        <pc:grpChg chg="mod">
          <ac:chgData name="장영훈" userId="cf5095d1-1c10-4b0e-b263-7acd6c30bdc2" providerId="ADAL" clId="{5E1FC45E-5279-4D42-BD20-D3C4B0717391}" dt="2023-04-24T06:17:58.405" v="502" actId="1076"/>
          <ac:grpSpMkLst>
            <pc:docMk/>
            <pc:sldMk cId="990490276" sldId="284"/>
            <ac:grpSpMk id="31" creationId="{C6632BBF-2925-FF5E-8901-8C99A92CC536}"/>
          </ac:grpSpMkLst>
        </pc:grpChg>
        <pc:grpChg chg="mod">
          <ac:chgData name="장영훈" userId="cf5095d1-1c10-4b0e-b263-7acd6c30bdc2" providerId="ADAL" clId="{5E1FC45E-5279-4D42-BD20-D3C4B0717391}" dt="2023-04-24T06:17:58.405" v="502" actId="1076"/>
          <ac:grpSpMkLst>
            <pc:docMk/>
            <pc:sldMk cId="990490276" sldId="284"/>
            <ac:grpSpMk id="36" creationId="{DA12A641-624D-28E4-8338-3B3158847CB3}"/>
          </ac:grpSpMkLst>
        </pc:grpChg>
        <pc:graphicFrameChg chg="mod">
          <ac:chgData name="장영훈" userId="cf5095d1-1c10-4b0e-b263-7acd6c30bdc2" providerId="ADAL" clId="{5E1FC45E-5279-4D42-BD20-D3C4B0717391}" dt="2023-04-24T06:17:52.332" v="501" actId="1076"/>
          <ac:graphicFrameMkLst>
            <pc:docMk/>
            <pc:sldMk cId="990490276" sldId="284"/>
            <ac:graphicFrameMk id="2" creationId="{48A6429D-7B49-EB59-BD22-8C4B7C5DE739}"/>
          </ac:graphicFrameMkLst>
        </pc:graphicFrameChg>
        <pc:picChg chg="mod">
          <ac:chgData name="장영훈" userId="cf5095d1-1c10-4b0e-b263-7acd6c30bdc2" providerId="ADAL" clId="{5E1FC45E-5279-4D42-BD20-D3C4B0717391}" dt="2023-04-24T06:17:58.405" v="502" actId="1076"/>
          <ac:picMkLst>
            <pc:docMk/>
            <pc:sldMk cId="990490276" sldId="284"/>
            <ac:picMk id="5" creationId="{7F2280D1-653A-D34C-6DDA-A7EB5A306396}"/>
          </ac:picMkLst>
        </pc:picChg>
        <pc:picChg chg="mod">
          <ac:chgData name="장영훈" userId="cf5095d1-1c10-4b0e-b263-7acd6c30bdc2" providerId="ADAL" clId="{5E1FC45E-5279-4D42-BD20-D3C4B0717391}" dt="2023-04-24T06:17:58.405" v="502" actId="1076"/>
          <ac:picMkLst>
            <pc:docMk/>
            <pc:sldMk cId="990490276" sldId="284"/>
            <ac:picMk id="6" creationId="{3ABAE590-9307-73E0-436A-D5330275F3DD}"/>
          </ac:picMkLst>
        </pc:picChg>
        <pc:picChg chg="mod">
          <ac:chgData name="장영훈" userId="cf5095d1-1c10-4b0e-b263-7acd6c30bdc2" providerId="ADAL" clId="{5E1FC45E-5279-4D42-BD20-D3C4B0717391}" dt="2023-04-24T06:17:58.405" v="502" actId="1076"/>
          <ac:picMkLst>
            <pc:docMk/>
            <pc:sldMk cId="990490276" sldId="284"/>
            <ac:picMk id="12" creationId="{94B5E7FD-3058-A76E-D506-7506BA1E9CF0}"/>
          </ac:picMkLst>
        </pc:picChg>
        <pc:picChg chg="mod">
          <ac:chgData name="장영훈" userId="cf5095d1-1c10-4b0e-b263-7acd6c30bdc2" providerId="ADAL" clId="{5E1FC45E-5279-4D42-BD20-D3C4B0717391}" dt="2023-04-24T06:17:58.405" v="502" actId="1076"/>
          <ac:picMkLst>
            <pc:docMk/>
            <pc:sldMk cId="990490276" sldId="284"/>
            <ac:picMk id="24" creationId="{6C5E624F-FCE1-FF1D-C486-1F0FF6B616F8}"/>
          </ac:picMkLst>
        </pc:picChg>
        <pc:picChg chg="mod">
          <ac:chgData name="장영훈" userId="cf5095d1-1c10-4b0e-b263-7acd6c30bdc2" providerId="ADAL" clId="{5E1FC45E-5279-4D42-BD20-D3C4B0717391}" dt="2023-04-24T06:17:58.405" v="502" actId="1076"/>
          <ac:picMkLst>
            <pc:docMk/>
            <pc:sldMk cId="990490276" sldId="284"/>
            <ac:picMk id="35" creationId="{0C2942C5-E2E3-2D93-25ED-96CA071F5105}"/>
          </ac:picMkLst>
        </pc:picChg>
      </pc:sldChg>
      <pc:sldChg chg="addSp modSp mod">
        <pc:chgData name="장영훈" userId="cf5095d1-1c10-4b0e-b263-7acd6c30bdc2" providerId="ADAL" clId="{5E1FC45E-5279-4D42-BD20-D3C4B0717391}" dt="2023-04-24T06:10:29.658" v="57"/>
        <pc:sldMkLst>
          <pc:docMk/>
          <pc:sldMk cId="3059598539" sldId="285"/>
        </pc:sldMkLst>
        <pc:spChg chg="add mod">
          <ac:chgData name="장영훈" userId="cf5095d1-1c10-4b0e-b263-7acd6c30bdc2" providerId="ADAL" clId="{5E1FC45E-5279-4D42-BD20-D3C4B0717391}" dt="2023-04-24T06:10:29.658" v="57"/>
          <ac:spMkLst>
            <pc:docMk/>
            <pc:sldMk cId="3059598539" sldId="285"/>
            <ac:spMk id="2" creationId="{EA3589B6-1A92-CAEC-5654-440DA7202B88}"/>
          </ac:spMkLst>
        </pc:spChg>
        <pc:spChg chg="mod">
          <ac:chgData name="장영훈" userId="cf5095d1-1c10-4b0e-b263-7acd6c30bdc2" providerId="ADAL" clId="{5E1FC45E-5279-4D42-BD20-D3C4B0717391}" dt="2023-04-24T06:10:15.754" v="52" actId="1035"/>
          <ac:spMkLst>
            <pc:docMk/>
            <pc:sldMk cId="3059598539" sldId="285"/>
            <ac:spMk id="13" creationId="{2487D9B6-D364-3368-0B07-8A2E10BF626D}"/>
          </ac:spMkLst>
        </pc:spChg>
        <pc:picChg chg="mod">
          <ac:chgData name="장영훈" userId="cf5095d1-1c10-4b0e-b263-7acd6c30bdc2" providerId="ADAL" clId="{5E1FC45E-5279-4D42-BD20-D3C4B0717391}" dt="2023-04-24T06:10:15.754" v="52" actId="1035"/>
          <ac:picMkLst>
            <pc:docMk/>
            <pc:sldMk cId="3059598539" sldId="285"/>
            <ac:picMk id="14" creationId="{D1B8E3D0-8009-C157-2864-5E12AAB6A086}"/>
          </ac:picMkLst>
        </pc:picChg>
        <pc:picChg chg="mod">
          <ac:chgData name="장영훈" userId="cf5095d1-1c10-4b0e-b263-7acd6c30bdc2" providerId="ADAL" clId="{5E1FC45E-5279-4D42-BD20-D3C4B0717391}" dt="2023-04-24T06:10:15.754" v="52" actId="1035"/>
          <ac:picMkLst>
            <pc:docMk/>
            <pc:sldMk cId="3059598539" sldId="285"/>
            <ac:picMk id="16" creationId="{9FCC8515-3F07-F059-D1A4-FD2EAD76E608}"/>
          </ac:picMkLst>
        </pc:picChg>
      </pc:sldChg>
      <pc:sldChg chg="addSp delSp modSp mod">
        <pc:chgData name="장영훈" userId="cf5095d1-1c10-4b0e-b263-7acd6c30bdc2" providerId="ADAL" clId="{5E1FC45E-5279-4D42-BD20-D3C4B0717391}" dt="2023-04-24T06:16:37.248" v="492" actId="20577"/>
        <pc:sldMkLst>
          <pc:docMk/>
          <pc:sldMk cId="3401682422" sldId="286"/>
        </pc:sldMkLst>
        <pc:spChg chg="add mod">
          <ac:chgData name="장영훈" userId="cf5095d1-1c10-4b0e-b263-7acd6c30bdc2" providerId="ADAL" clId="{5E1FC45E-5279-4D42-BD20-D3C4B0717391}" dt="2023-04-24T06:16:37.248" v="492" actId="20577"/>
          <ac:spMkLst>
            <pc:docMk/>
            <pc:sldMk cId="3401682422" sldId="286"/>
            <ac:spMk id="2" creationId="{986D65E6-6CBC-BE83-4E00-5DF0D3CBD4E8}"/>
          </ac:spMkLst>
        </pc:spChg>
        <pc:spChg chg="del">
          <ac:chgData name="장영훈" userId="cf5095d1-1c10-4b0e-b263-7acd6c30bdc2" providerId="ADAL" clId="{5E1FC45E-5279-4D42-BD20-D3C4B0717391}" dt="2023-04-24T06:12:38.049" v="278" actId="478"/>
          <ac:spMkLst>
            <pc:docMk/>
            <pc:sldMk cId="3401682422" sldId="286"/>
            <ac:spMk id="3" creationId="{E0560ABE-462F-8872-D464-274A6FBF198C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5" creationId="{FB68DD83-975C-B88D-B8DA-B46C4227E754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6" creationId="{D1E5A882-BBE3-1891-A76D-0B61D05DE6A5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7" creationId="{3BC3FC99-57CE-63BF-7AE9-99C651C87B56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8" creationId="{211B30A1-A9F2-A2A7-1CFD-282B7C0C097F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15" creationId="{952657BC-26E6-43A0-7E0A-BE8E258490BC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16" creationId="{999C1E4D-8428-E36E-CF51-EEDE72A8B25A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17" creationId="{595642A1-5C13-F86B-1980-A011937E3E9D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18" creationId="{906A95B8-01DD-41C7-ACF3-A070907CCE6E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19" creationId="{D6519939-69F4-BCF7-BB1A-24930D447819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20" creationId="{1AD7300D-54C9-CBD1-CB33-AA465C4ADA23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21" creationId="{08E2DC76-2278-B217-465D-69F96634E374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23" creationId="{D0BA0B55-0CFE-8893-C7AB-27B875355E47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24" creationId="{99A4E054-3A16-ADF4-5C59-5F13820311C3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25" creationId="{CD083593-4B9A-2FD0-BA76-798AD8FB8237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27" creationId="{6DA0F319-C764-41F3-12EC-54E245EFD7DF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28" creationId="{E7C5EDFD-AE90-7C86-EC68-0516D3B80E4A}"/>
          </ac:spMkLst>
        </pc:spChg>
        <pc:spChg chg="mod">
          <ac:chgData name="장영훈" userId="cf5095d1-1c10-4b0e-b263-7acd6c30bdc2" providerId="ADAL" clId="{5E1FC45E-5279-4D42-BD20-D3C4B0717391}" dt="2023-04-24T06:12:34.629" v="277" actId="1038"/>
          <ac:spMkLst>
            <pc:docMk/>
            <pc:sldMk cId="3401682422" sldId="286"/>
            <ac:spMk id="29" creationId="{6412D905-C8B3-A4DA-8916-D9A01B3A3E1C}"/>
          </ac:spMkLst>
        </pc:spChg>
        <pc:graphicFrameChg chg="mod">
          <ac:chgData name="장영훈" userId="cf5095d1-1c10-4b0e-b263-7acd6c30bdc2" providerId="ADAL" clId="{5E1FC45E-5279-4D42-BD20-D3C4B0717391}" dt="2023-04-24T06:12:34.629" v="277" actId="1038"/>
          <ac:graphicFrameMkLst>
            <pc:docMk/>
            <pc:sldMk cId="3401682422" sldId="286"/>
            <ac:graphicFrameMk id="4" creationId="{A2A41D36-DBC9-112D-2F1F-0729FDC279D4}"/>
          </ac:graphicFrameMkLst>
        </pc:graphicFrameChg>
        <pc:graphicFrameChg chg="mod">
          <ac:chgData name="장영훈" userId="cf5095d1-1c10-4b0e-b263-7acd6c30bdc2" providerId="ADAL" clId="{5E1FC45E-5279-4D42-BD20-D3C4B0717391}" dt="2023-04-24T06:12:34.629" v="277" actId="1038"/>
          <ac:graphicFrameMkLst>
            <pc:docMk/>
            <pc:sldMk cId="3401682422" sldId="286"/>
            <ac:graphicFrameMk id="31" creationId="{6842CF81-9177-4542-84FD-176080D071DD}"/>
          </ac:graphicFrameMkLst>
        </pc:graphicFrameChg>
        <pc:graphicFrameChg chg="mod">
          <ac:chgData name="장영훈" userId="cf5095d1-1c10-4b0e-b263-7acd6c30bdc2" providerId="ADAL" clId="{5E1FC45E-5279-4D42-BD20-D3C4B0717391}" dt="2023-04-24T06:12:34.629" v="277" actId="1038"/>
          <ac:graphicFrameMkLst>
            <pc:docMk/>
            <pc:sldMk cId="3401682422" sldId="286"/>
            <ac:graphicFrameMk id="32" creationId="{E86A625E-FE59-4AA7-9F5B-ECE9DC9BD18B}"/>
          </ac:graphicFrameMkLst>
        </pc:graphicFrameChg>
        <pc:graphicFrameChg chg="mod">
          <ac:chgData name="장영훈" userId="cf5095d1-1c10-4b0e-b263-7acd6c30bdc2" providerId="ADAL" clId="{5E1FC45E-5279-4D42-BD20-D3C4B0717391}" dt="2023-04-24T06:12:34.629" v="277" actId="1038"/>
          <ac:graphicFrameMkLst>
            <pc:docMk/>
            <pc:sldMk cId="3401682422" sldId="286"/>
            <ac:graphicFrameMk id="33" creationId="{13554314-04EA-4144-AEA9-81D671F44DE6}"/>
          </ac:graphicFrameMkLst>
        </pc:graphicFrameChg>
        <pc:graphicFrameChg chg="mod">
          <ac:chgData name="장영훈" userId="cf5095d1-1c10-4b0e-b263-7acd6c30bdc2" providerId="ADAL" clId="{5E1FC45E-5279-4D42-BD20-D3C4B0717391}" dt="2023-04-24T06:12:34.629" v="277" actId="1038"/>
          <ac:graphicFrameMkLst>
            <pc:docMk/>
            <pc:sldMk cId="3401682422" sldId="286"/>
            <ac:graphicFrameMk id="64" creationId="{66B6EF1A-050C-4E6F-ADCF-363247FFE564}"/>
          </ac:graphicFrameMkLst>
        </pc:graphicFrameChg>
      </pc:sldChg>
      <pc:sldChg chg="addSp delSp modSp mod">
        <pc:chgData name="장영훈" userId="cf5095d1-1c10-4b0e-b263-7acd6c30bdc2" providerId="ADAL" clId="{5E1FC45E-5279-4D42-BD20-D3C4B0717391}" dt="2023-04-24T07:36:20.814" v="672" actId="22"/>
        <pc:sldMkLst>
          <pc:docMk/>
          <pc:sldMk cId="2690643564" sldId="287"/>
        </pc:sldMkLst>
        <pc:spChg chg="del">
          <ac:chgData name="장영훈" userId="cf5095d1-1c10-4b0e-b263-7acd6c30bdc2" providerId="ADAL" clId="{5E1FC45E-5279-4D42-BD20-D3C4B0717391}" dt="2023-04-24T06:18:16.926" v="503" actId="478"/>
          <ac:spMkLst>
            <pc:docMk/>
            <pc:sldMk cId="2690643564" sldId="287"/>
            <ac:spMk id="2" creationId="{A5BA2435-D06B-0FA4-0A35-299E3738F5E9}"/>
          </ac:spMkLst>
        </pc:spChg>
        <pc:spChg chg="add mod">
          <ac:chgData name="장영훈" userId="cf5095d1-1c10-4b0e-b263-7acd6c30bdc2" providerId="ADAL" clId="{5E1FC45E-5279-4D42-BD20-D3C4B0717391}" dt="2023-04-24T06:20:50.178" v="668" actId="20577"/>
          <ac:spMkLst>
            <pc:docMk/>
            <pc:sldMk cId="2690643564" sldId="287"/>
            <ac:spMk id="3" creationId="{85D7A961-8800-F204-B8CB-158906C07EDC}"/>
          </ac:spMkLst>
        </pc:spChg>
        <pc:spChg chg="add del">
          <ac:chgData name="장영훈" userId="cf5095d1-1c10-4b0e-b263-7acd6c30bdc2" providerId="ADAL" clId="{5E1FC45E-5279-4D42-BD20-D3C4B0717391}" dt="2023-04-24T07:36:13.257" v="670" actId="22"/>
          <ac:spMkLst>
            <pc:docMk/>
            <pc:sldMk cId="2690643564" sldId="287"/>
            <ac:spMk id="4" creationId="{09FA402C-3662-197B-D0B8-76F35C3EAC01}"/>
          </ac:spMkLst>
        </pc:spChg>
        <pc:spChg chg="add del">
          <ac:chgData name="장영훈" userId="cf5095d1-1c10-4b0e-b263-7acd6c30bdc2" providerId="ADAL" clId="{5E1FC45E-5279-4D42-BD20-D3C4B0717391}" dt="2023-04-24T07:36:20.814" v="672" actId="22"/>
          <ac:spMkLst>
            <pc:docMk/>
            <pc:sldMk cId="2690643564" sldId="287"/>
            <ac:spMk id="6" creationId="{A9E6600E-E804-A327-BA2D-A33E3CBAAEE4}"/>
          </ac:spMkLst>
        </pc:spChg>
      </pc:sldChg>
      <pc:sldChg chg="addSp delSp modSp add mod">
        <pc:chgData name="장영훈" userId="cf5095d1-1c10-4b0e-b263-7acd6c30bdc2" providerId="ADAL" clId="{5E1FC45E-5279-4D42-BD20-D3C4B0717391}" dt="2023-04-24T07:37:22.698" v="683"/>
        <pc:sldMkLst>
          <pc:docMk/>
          <pc:sldMk cId="1969640124" sldId="288"/>
        </pc:sldMkLst>
        <pc:spChg chg="del">
          <ac:chgData name="장영훈" userId="cf5095d1-1c10-4b0e-b263-7acd6c30bdc2" providerId="ADAL" clId="{5E1FC45E-5279-4D42-BD20-D3C4B0717391}" dt="2023-04-24T07:36:45.245" v="677" actId="478"/>
          <ac:spMkLst>
            <pc:docMk/>
            <pc:sldMk cId="1969640124" sldId="288"/>
            <ac:spMk id="2" creationId="{BE8BCA52-E4D9-6E6A-DBFD-468EC35A0FFD}"/>
          </ac:spMkLst>
        </pc:spChg>
        <pc:spChg chg="mod">
          <ac:chgData name="장영훈" userId="cf5095d1-1c10-4b0e-b263-7acd6c30bdc2" providerId="ADAL" clId="{5E1FC45E-5279-4D42-BD20-D3C4B0717391}" dt="2023-04-24T07:36:34.258" v="674" actId="1076"/>
          <ac:spMkLst>
            <pc:docMk/>
            <pc:sldMk cId="1969640124" sldId="288"/>
            <ac:spMk id="4" creationId="{99DE19C5-8C98-D49B-DBEE-2D5035AD0EF4}"/>
          </ac:spMkLst>
        </pc:spChg>
        <pc:spChg chg="mod">
          <ac:chgData name="장영훈" userId="cf5095d1-1c10-4b0e-b263-7acd6c30bdc2" providerId="ADAL" clId="{5E1FC45E-5279-4D42-BD20-D3C4B0717391}" dt="2023-04-24T07:36:34.258" v="674" actId="1076"/>
          <ac:spMkLst>
            <pc:docMk/>
            <pc:sldMk cId="1969640124" sldId="288"/>
            <ac:spMk id="5" creationId="{E36F80AA-C7F1-6D94-CF1A-F547FA6344F3}"/>
          </ac:spMkLst>
        </pc:spChg>
        <pc:spChg chg="add mod">
          <ac:chgData name="장영훈" userId="cf5095d1-1c10-4b0e-b263-7acd6c30bdc2" providerId="ADAL" clId="{5E1FC45E-5279-4D42-BD20-D3C4B0717391}" dt="2023-04-24T07:37:22.698" v="683"/>
          <ac:spMkLst>
            <pc:docMk/>
            <pc:sldMk cId="1969640124" sldId="288"/>
            <ac:spMk id="6" creationId="{4B5EBBAC-30A6-0D09-5E47-346D7A8F85A5}"/>
          </ac:spMkLst>
        </pc:spChg>
        <pc:spChg chg="mod">
          <ac:chgData name="장영훈" userId="cf5095d1-1c10-4b0e-b263-7acd6c30bdc2" providerId="ADAL" clId="{5E1FC45E-5279-4D42-BD20-D3C4B0717391}" dt="2023-04-24T07:36:34.258" v="674" actId="1076"/>
          <ac:spMkLst>
            <pc:docMk/>
            <pc:sldMk cId="1969640124" sldId="288"/>
            <ac:spMk id="8" creationId="{13959659-9FE6-7A56-3D59-239B4E3B6AF1}"/>
          </ac:spMkLst>
        </pc:spChg>
        <pc:spChg chg="mod">
          <ac:chgData name="장영훈" userId="cf5095d1-1c10-4b0e-b263-7acd6c30bdc2" providerId="ADAL" clId="{5E1FC45E-5279-4D42-BD20-D3C4B0717391}" dt="2023-04-24T07:36:34.258" v="674" actId="1076"/>
          <ac:spMkLst>
            <pc:docMk/>
            <pc:sldMk cId="1969640124" sldId="288"/>
            <ac:spMk id="10" creationId="{60928491-CF1D-19ED-0074-275CD576CF2F}"/>
          </ac:spMkLst>
        </pc:spChg>
        <pc:spChg chg="mod">
          <ac:chgData name="장영훈" userId="cf5095d1-1c10-4b0e-b263-7acd6c30bdc2" providerId="ADAL" clId="{5E1FC45E-5279-4D42-BD20-D3C4B0717391}" dt="2023-04-24T07:36:34.258" v="674" actId="1076"/>
          <ac:spMkLst>
            <pc:docMk/>
            <pc:sldMk cId="1969640124" sldId="288"/>
            <ac:spMk id="12" creationId="{AE099D22-8CAD-5CE7-393F-310770FEFA6C}"/>
          </ac:spMkLst>
        </pc:spChg>
        <pc:spChg chg="mod">
          <ac:chgData name="장영훈" userId="cf5095d1-1c10-4b0e-b263-7acd6c30bdc2" providerId="ADAL" clId="{5E1FC45E-5279-4D42-BD20-D3C4B0717391}" dt="2023-04-24T07:36:34.258" v="674" actId="1076"/>
          <ac:spMkLst>
            <pc:docMk/>
            <pc:sldMk cId="1969640124" sldId="288"/>
            <ac:spMk id="16" creationId="{7A72BA4F-D067-AF60-CE8F-9229CBC26590}"/>
          </ac:spMkLst>
        </pc:spChg>
        <pc:graphicFrameChg chg="mod">
          <ac:chgData name="장영훈" userId="cf5095d1-1c10-4b0e-b263-7acd6c30bdc2" providerId="ADAL" clId="{5E1FC45E-5279-4D42-BD20-D3C4B0717391}" dt="2023-04-24T07:36:34.258" v="674" actId="1076"/>
          <ac:graphicFrameMkLst>
            <pc:docMk/>
            <pc:sldMk cId="1969640124" sldId="288"/>
            <ac:graphicFrameMk id="3" creationId="{E99EAC8B-1BCD-4A46-9B66-2C0857F8FD89}"/>
          </ac:graphicFrameMkLst>
        </pc:graphicFrameChg>
        <pc:cxnChg chg="mod">
          <ac:chgData name="장영훈" userId="cf5095d1-1c10-4b0e-b263-7acd6c30bdc2" providerId="ADAL" clId="{5E1FC45E-5279-4D42-BD20-D3C4B0717391}" dt="2023-04-24T07:36:34.258" v="674" actId="1076"/>
          <ac:cxnSpMkLst>
            <pc:docMk/>
            <pc:sldMk cId="1969640124" sldId="288"/>
            <ac:cxnSpMk id="7" creationId="{8A6A5696-12A5-4CA0-9821-6D20A6B31B72}"/>
          </ac:cxnSpMkLst>
        </pc:cxnChg>
        <pc:cxnChg chg="mod">
          <ac:chgData name="장영훈" userId="cf5095d1-1c10-4b0e-b263-7acd6c30bdc2" providerId="ADAL" clId="{5E1FC45E-5279-4D42-BD20-D3C4B0717391}" dt="2023-04-24T07:36:34.258" v="674" actId="1076"/>
          <ac:cxnSpMkLst>
            <pc:docMk/>
            <pc:sldMk cId="1969640124" sldId="288"/>
            <ac:cxnSpMk id="9" creationId="{BFFAB6F1-1918-AB9E-721E-BA42B90EA6F8}"/>
          </ac:cxnSpMkLst>
        </pc:cxnChg>
        <pc:cxnChg chg="mod">
          <ac:chgData name="장영훈" userId="cf5095d1-1c10-4b0e-b263-7acd6c30bdc2" providerId="ADAL" clId="{5E1FC45E-5279-4D42-BD20-D3C4B0717391}" dt="2023-04-24T07:36:34.258" v="674" actId="1076"/>
          <ac:cxnSpMkLst>
            <pc:docMk/>
            <pc:sldMk cId="1969640124" sldId="288"/>
            <ac:cxnSpMk id="11" creationId="{99DB0436-FFB6-E4DA-6BA7-EC5F8FC61C75}"/>
          </ac:cxnSpMkLst>
        </pc:cxnChg>
        <pc:cxnChg chg="mod">
          <ac:chgData name="장영훈" userId="cf5095d1-1c10-4b0e-b263-7acd6c30bdc2" providerId="ADAL" clId="{5E1FC45E-5279-4D42-BD20-D3C4B0717391}" dt="2023-04-24T07:36:34.258" v="674" actId="1076"/>
          <ac:cxnSpMkLst>
            <pc:docMk/>
            <pc:sldMk cId="1969640124" sldId="288"/>
            <ac:cxnSpMk id="13" creationId="{9EE0961F-CC19-07E0-CAEE-AEF648FD9E33}"/>
          </ac:cxnSpMkLst>
        </pc:cxnChg>
        <pc:cxnChg chg="mod">
          <ac:chgData name="장영훈" userId="cf5095d1-1c10-4b0e-b263-7acd6c30bdc2" providerId="ADAL" clId="{5E1FC45E-5279-4D42-BD20-D3C4B0717391}" dt="2023-04-24T07:36:34.258" v="674" actId="1076"/>
          <ac:cxnSpMkLst>
            <pc:docMk/>
            <pc:sldMk cId="1969640124" sldId="288"/>
            <ac:cxnSpMk id="17" creationId="{694B3405-C0D0-EF78-3D9D-0F3A4FA6331A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histone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histone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histone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histone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histone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signaling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signaling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signaling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signaling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signaling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qPCR\QPCR%20primer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3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3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qPCR\QPCR%20primer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histone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702\Desktop\Metfromin\life\WB%20band%20&#51221;&#47049;%20histone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800"/>
              <a:t>VCAM1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VCAM1!$S$11:$S$12</c:f>
                <c:numCache>
                  <c:formatCode>General</c:formatCode>
                  <c:ptCount val="2"/>
                  <c:pt idx="0">
                    <c:v>0.20553236401868971</c:v>
                  </c:pt>
                  <c:pt idx="1">
                    <c:v>1.10347868752755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VCAM1!$Q$11:$Q$12</c:f>
              <c:numCache>
                <c:formatCode>General</c:formatCode>
                <c:ptCount val="2"/>
              </c:numCache>
            </c:numRef>
          </c:cat>
          <c:val>
            <c:numRef>
              <c:f>VCAM1!$R$11:$R$12</c:f>
              <c:numCache>
                <c:formatCode>General</c:formatCode>
                <c:ptCount val="2"/>
                <c:pt idx="0">
                  <c:v>1</c:v>
                </c:pt>
                <c:pt idx="1">
                  <c:v>9.54657674955810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3E-46F1-A375-36FE196172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3K36me2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3K36me2!$S$11:$S$14</c:f>
                <c:numCache>
                  <c:formatCode>General</c:formatCode>
                  <c:ptCount val="4"/>
                  <c:pt idx="0">
                    <c:v>6.71907574992434E-2</c:v>
                  </c:pt>
                  <c:pt idx="1">
                    <c:v>0.16025327230298989</c:v>
                  </c:pt>
                  <c:pt idx="2">
                    <c:v>0.11972967655462211</c:v>
                  </c:pt>
                  <c:pt idx="3">
                    <c:v>0.114839496115782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3K36me2!$Q$3:$Q$6</c:f>
              <c:numCache>
                <c:formatCode>General</c:formatCode>
                <c:ptCount val="4"/>
              </c:numCache>
            </c:numRef>
          </c:cat>
          <c:val>
            <c:numRef>
              <c:f>H3K36me2!$R$11:$R$14</c:f>
              <c:numCache>
                <c:formatCode>General</c:formatCode>
                <c:ptCount val="4"/>
                <c:pt idx="0">
                  <c:v>1</c:v>
                </c:pt>
                <c:pt idx="1">
                  <c:v>1.0946715968131782</c:v>
                </c:pt>
                <c:pt idx="2">
                  <c:v>0.65306898257650292</c:v>
                </c:pt>
                <c:pt idx="3">
                  <c:v>0.658593631537631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618-4065-8E0B-FEE2675749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3K36me3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3K36me3!$S$11:$S$14</c:f>
                <c:numCache>
                  <c:formatCode>General</c:formatCode>
                  <c:ptCount val="4"/>
                  <c:pt idx="0">
                    <c:v>5.7909098289724036E-2</c:v>
                  </c:pt>
                  <c:pt idx="1">
                    <c:v>0.26319236601332435</c:v>
                  </c:pt>
                  <c:pt idx="2">
                    <c:v>0.2135607717980911</c:v>
                  </c:pt>
                  <c:pt idx="3">
                    <c:v>0.119006092183622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3K36me3!$Q$3:$Q$6</c:f>
              <c:numCache>
                <c:formatCode>General</c:formatCode>
                <c:ptCount val="4"/>
              </c:numCache>
            </c:numRef>
          </c:cat>
          <c:val>
            <c:numRef>
              <c:f>H3K36me3!$R$11:$R$14</c:f>
              <c:numCache>
                <c:formatCode>General</c:formatCode>
                <c:ptCount val="4"/>
                <c:pt idx="0">
                  <c:v>1</c:v>
                </c:pt>
                <c:pt idx="1">
                  <c:v>0.72501980916413566</c:v>
                </c:pt>
                <c:pt idx="2">
                  <c:v>0.57005396600124669</c:v>
                </c:pt>
                <c:pt idx="3">
                  <c:v>0.39419961539960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2A-46EE-8621-4F504FC2BB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3K9me2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3K9me2!$S$11:$S$14</c:f>
                <c:numCache>
                  <c:formatCode>General</c:formatCode>
                  <c:ptCount val="4"/>
                  <c:pt idx="0">
                    <c:v>0.15568279090916409</c:v>
                  </c:pt>
                  <c:pt idx="1">
                    <c:v>5.3643965873278146E-2</c:v>
                  </c:pt>
                  <c:pt idx="2">
                    <c:v>0.12658441709927154</c:v>
                  </c:pt>
                  <c:pt idx="3">
                    <c:v>0.17535057380096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3K9me2!$Q$3:$Q$6</c:f>
              <c:numCache>
                <c:formatCode>General</c:formatCode>
                <c:ptCount val="4"/>
              </c:numCache>
            </c:numRef>
          </c:cat>
          <c:val>
            <c:numRef>
              <c:f>H3K9me2!$R$11:$R$14</c:f>
              <c:numCache>
                <c:formatCode>General</c:formatCode>
                <c:ptCount val="4"/>
                <c:pt idx="0">
                  <c:v>1.0000000000000002</c:v>
                </c:pt>
                <c:pt idx="1">
                  <c:v>0.67487602761727583</c:v>
                </c:pt>
                <c:pt idx="2">
                  <c:v>0.80535572435113567</c:v>
                </c:pt>
                <c:pt idx="3">
                  <c:v>0.413627212482536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B1-4B53-B421-FC1FA24E56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3K9me3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3K9me3!$S$11:$S$14</c:f>
                <c:numCache>
                  <c:formatCode>General</c:formatCode>
                  <c:ptCount val="4"/>
                  <c:pt idx="0">
                    <c:v>0.22167222345739793</c:v>
                  </c:pt>
                  <c:pt idx="1">
                    <c:v>0.21429471425155258</c:v>
                  </c:pt>
                  <c:pt idx="2">
                    <c:v>0.12890172479722994</c:v>
                  </c:pt>
                  <c:pt idx="3">
                    <c:v>5.338013225983275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3K9me3!$Q$3:$Q$6</c:f>
              <c:numCache>
                <c:formatCode>General</c:formatCode>
                <c:ptCount val="4"/>
              </c:numCache>
            </c:numRef>
          </c:cat>
          <c:val>
            <c:numRef>
              <c:f>H3K9me3!$R$11:$R$14</c:f>
              <c:numCache>
                <c:formatCode>General</c:formatCode>
                <c:ptCount val="4"/>
                <c:pt idx="0">
                  <c:v>1</c:v>
                </c:pt>
                <c:pt idx="1">
                  <c:v>1.1781726089491837</c:v>
                </c:pt>
                <c:pt idx="2">
                  <c:v>0.73898483076664301</c:v>
                </c:pt>
                <c:pt idx="3">
                  <c:v>0.783762340326654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38-42EF-925E-109372E779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3K27me2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3K27me2!$S$11:$S$14</c:f>
                <c:numCache>
                  <c:formatCode>General</c:formatCode>
                  <c:ptCount val="4"/>
                  <c:pt idx="0">
                    <c:v>0.10868371084077892</c:v>
                  </c:pt>
                  <c:pt idx="1">
                    <c:v>0.11173628076171302</c:v>
                  </c:pt>
                  <c:pt idx="2">
                    <c:v>0.1469694507066987</c:v>
                  </c:pt>
                  <c:pt idx="3">
                    <c:v>2.844033700367763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3K27me2!$Q$3:$Q$6</c:f>
              <c:numCache>
                <c:formatCode>General</c:formatCode>
                <c:ptCount val="4"/>
              </c:numCache>
            </c:numRef>
          </c:cat>
          <c:val>
            <c:numRef>
              <c:f>H3K27me2!$R$11:$R$14</c:f>
              <c:numCache>
                <c:formatCode>General</c:formatCode>
                <c:ptCount val="4"/>
                <c:pt idx="0">
                  <c:v>1</c:v>
                </c:pt>
                <c:pt idx="1">
                  <c:v>0.98174570911839043</c:v>
                </c:pt>
                <c:pt idx="2">
                  <c:v>0.70618164804728478</c:v>
                </c:pt>
                <c:pt idx="3">
                  <c:v>0.50728386913785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9F-4131-95C2-62F9C09770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dirty="0"/>
              <a:t>p-p38 MAPK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-p38 MAPK'!$S$11:$S$14</c:f>
                <c:numCache>
                  <c:formatCode>General</c:formatCode>
                  <c:ptCount val="4"/>
                  <c:pt idx="0">
                    <c:v>0.17703549840227992</c:v>
                  </c:pt>
                  <c:pt idx="1">
                    <c:v>0.49992434904466643</c:v>
                  </c:pt>
                  <c:pt idx="2">
                    <c:v>0.30288561889344201</c:v>
                  </c:pt>
                  <c:pt idx="3">
                    <c:v>0.241018458098770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-p38 MAPK'!$Q$3:$Q$6</c:f>
              <c:numCache>
                <c:formatCode>General</c:formatCode>
                <c:ptCount val="4"/>
              </c:numCache>
            </c:numRef>
          </c:cat>
          <c:val>
            <c:numRef>
              <c:f>'p-p38 MAPK'!$R$11:$R$14</c:f>
              <c:numCache>
                <c:formatCode>General</c:formatCode>
                <c:ptCount val="4"/>
                <c:pt idx="0">
                  <c:v>1</c:v>
                </c:pt>
                <c:pt idx="1">
                  <c:v>3.0478184359541731</c:v>
                </c:pt>
                <c:pt idx="2">
                  <c:v>0.97332259529520648</c:v>
                </c:pt>
                <c:pt idx="3">
                  <c:v>1.52599441385406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95-4892-9E35-EE6339622F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dirty="0"/>
              <a:t>p-p6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-p65'!$S$11:$S$14</c:f>
                <c:numCache>
                  <c:formatCode>General</c:formatCode>
                  <c:ptCount val="4"/>
                  <c:pt idx="0">
                    <c:v>0.17215219088073608</c:v>
                  </c:pt>
                  <c:pt idx="1">
                    <c:v>7.3720556997013312E-2</c:v>
                  </c:pt>
                  <c:pt idx="2">
                    <c:v>2.6886834200441474E-2</c:v>
                  </c:pt>
                  <c:pt idx="3">
                    <c:v>6.762533151014475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-p65'!$Q$3:$Q$6</c:f>
              <c:numCache>
                <c:formatCode>General</c:formatCode>
                <c:ptCount val="4"/>
              </c:numCache>
            </c:numRef>
          </c:cat>
          <c:val>
            <c:numRef>
              <c:f>'p-p65'!$R$11:$R$14</c:f>
              <c:numCache>
                <c:formatCode>General</c:formatCode>
                <c:ptCount val="4"/>
                <c:pt idx="0">
                  <c:v>1</c:v>
                </c:pt>
                <c:pt idx="1">
                  <c:v>0.36962842077952901</c:v>
                </c:pt>
                <c:pt idx="2">
                  <c:v>1.2747667595223147</c:v>
                </c:pt>
                <c:pt idx="3">
                  <c:v>0.473899275603246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10-452F-8324-8731AF71EA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dirty="0"/>
              <a:t>p-STAT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-STAT3'!$S$11:$S$14</c:f>
                <c:numCache>
                  <c:formatCode>General</c:formatCode>
                  <c:ptCount val="4"/>
                  <c:pt idx="0">
                    <c:v>0.11130910229056568</c:v>
                  </c:pt>
                  <c:pt idx="1">
                    <c:v>0.26645633777516664</c:v>
                  </c:pt>
                  <c:pt idx="2">
                    <c:v>0.46253495432756697</c:v>
                  </c:pt>
                  <c:pt idx="3">
                    <c:v>0.342378867699791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-STAT3'!$Q$3:$Q$6</c:f>
              <c:numCache>
                <c:formatCode>General</c:formatCode>
                <c:ptCount val="4"/>
              </c:numCache>
            </c:numRef>
          </c:cat>
          <c:val>
            <c:numRef>
              <c:f>'p-STAT3'!$R$11:$R$14</c:f>
              <c:numCache>
                <c:formatCode>General</c:formatCode>
                <c:ptCount val="4"/>
                <c:pt idx="0">
                  <c:v>1</c:v>
                </c:pt>
                <c:pt idx="1">
                  <c:v>1.1307931304415535</c:v>
                </c:pt>
                <c:pt idx="2">
                  <c:v>0.71331199759984409</c:v>
                </c:pt>
                <c:pt idx="3">
                  <c:v>1.38740230106307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C17-4BAF-BA90-D07F75F334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p-STAT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-STAT5'!$S$11:$S$14</c:f>
                <c:numCache>
                  <c:formatCode>General</c:formatCode>
                  <c:ptCount val="4"/>
                  <c:pt idx="0">
                    <c:v>0.26467331526702398</c:v>
                  </c:pt>
                  <c:pt idx="1">
                    <c:v>0.20042542421575435</c:v>
                  </c:pt>
                  <c:pt idx="2">
                    <c:v>0.439638508543992</c:v>
                  </c:pt>
                  <c:pt idx="3">
                    <c:v>0.154782136794501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-STAT5'!$Q$3:$Q$6</c:f>
              <c:numCache>
                <c:formatCode>General</c:formatCode>
                <c:ptCount val="4"/>
              </c:numCache>
            </c:numRef>
          </c:cat>
          <c:val>
            <c:numRef>
              <c:f>'p-STAT5'!$R$11:$R$14</c:f>
              <c:numCache>
                <c:formatCode>General</c:formatCode>
                <c:ptCount val="4"/>
                <c:pt idx="0">
                  <c:v>0.99999999999999989</c:v>
                </c:pt>
                <c:pt idx="1">
                  <c:v>0.58580299984413853</c:v>
                </c:pt>
                <c:pt idx="2">
                  <c:v>0.77856105665006392</c:v>
                </c:pt>
                <c:pt idx="3">
                  <c:v>0.414884939256761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ED-45D9-9EBD-DFF22AE72A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dirty="0"/>
              <a:t>p-mTOR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-mTOR'!$S$11:$S$14</c:f>
                <c:numCache>
                  <c:formatCode>General</c:formatCode>
                  <c:ptCount val="4"/>
                  <c:pt idx="0">
                    <c:v>0.17215219088073608</c:v>
                  </c:pt>
                  <c:pt idx="1">
                    <c:v>0.1335189037666869</c:v>
                  </c:pt>
                  <c:pt idx="2">
                    <c:v>0.22186734281999643</c:v>
                  </c:pt>
                  <c:pt idx="3">
                    <c:v>0.339674844889577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-mTOR'!$Q$3:$Q$6</c:f>
              <c:numCache>
                <c:formatCode>General</c:formatCode>
                <c:ptCount val="4"/>
              </c:numCache>
            </c:numRef>
          </c:cat>
          <c:val>
            <c:numRef>
              <c:f>'p-mTOR'!$R$11:$R$14</c:f>
              <c:numCache>
                <c:formatCode>General</c:formatCode>
                <c:ptCount val="4"/>
                <c:pt idx="0">
                  <c:v>1</c:v>
                </c:pt>
                <c:pt idx="1">
                  <c:v>0.97459818528231157</c:v>
                </c:pt>
                <c:pt idx="2">
                  <c:v>1.0581068148053923</c:v>
                </c:pt>
                <c:pt idx="3">
                  <c:v>1.02101749057871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F5-4A76-AD40-4D98A4FE35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800"/>
              <a:t>MMP-2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MP-2'!$S$11:$S$12</c:f>
                <c:numCache>
                  <c:formatCode>General</c:formatCode>
                  <c:ptCount val="2"/>
                  <c:pt idx="0">
                    <c:v>0.29791199937043583</c:v>
                  </c:pt>
                  <c:pt idx="1">
                    <c:v>0.277657150289301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MMP-2'!$Q$11:$Q$12</c:f>
              <c:numCache>
                <c:formatCode>General</c:formatCode>
                <c:ptCount val="2"/>
              </c:numCache>
            </c:numRef>
          </c:cat>
          <c:val>
            <c:numRef>
              <c:f>'MMP-2'!$R$11:$R$12</c:f>
              <c:numCache>
                <c:formatCode>General</c:formatCode>
                <c:ptCount val="2"/>
                <c:pt idx="0">
                  <c:v>1</c:v>
                </c:pt>
                <c:pt idx="1">
                  <c:v>2.2890734266986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617-461C-BD4C-0C008F69C7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apa (2)'!$P$6</c:f>
              <c:strCache>
                <c:ptCount val="1"/>
                <c:pt idx="0">
                  <c:v>A549-W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apa (2)'!$Q$13:$T$13</c:f>
                <c:numCache>
                  <c:formatCode>General</c:formatCode>
                  <c:ptCount val="4"/>
                  <c:pt idx="0">
                    <c:v>5.5229863672490109E-2</c:v>
                  </c:pt>
                  <c:pt idx="1">
                    <c:v>9.2392907698825924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apa (2)'!$Q$5:$R$5</c:f>
              <c:strCache>
                <c:ptCount val="2"/>
                <c:pt idx="0">
                  <c:v>BMP5</c:v>
                </c:pt>
                <c:pt idx="1">
                  <c:v>VCAM</c:v>
                </c:pt>
              </c:strCache>
            </c:strRef>
          </c:cat>
          <c:val>
            <c:numRef>
              <c:f>'Rapa (2)'!$Q$6:$R$6</c:f>
              <c:numCache>
                <c:formatCode>General</c:formatCode>
                <c:ptCount val="2"/>
                <c:pt idx="0">
                  <c:v>1.0029737372614731</c:v>
                </c:pt>
                <c:pt idx="1">
                  <c:v>1.00008495751034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4C-44B8-82D9-ACA5B6CF704C}"/>
            </c:ext>
          </c:extLst>
        </c:ser>
        <c:ser>
          <c:idx val="1"/>
          <c:order val="1"/>
          <c:tx>
            <c:strRef>
              <c:f>'Rapa (2)'!$P$7</c:f>
              <c:strCache>
                <c:ptCount val="1"/>
                <c:pt idx="0">
                  <c:v>A549-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apa (2)'!$Q$14:$T$14</c:f>
                <c:numCache>
                  <c:formatCode>General</c:formatCode>
                  <c:ptCount val="4"/>
                  <c:pt idx="0">
                    <c:v>0.60312544310094784</c:v>
                  </c:pt>
                  <c:pt idx="1">
                    <c:v>0.510100041016026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apa (2)'!$Q$5:$R$5</c:f>
              <c:strCache>
                <c:ptCount val="2"/>
                <c:pt idx="0">
                  <c:v>BMP5</c:v>
                </c:pt>
                <c:pt idx="1">
                  <c:v>VCAM</c:v>
                </c:pt>
              </c:strCache>
            </c:strRef>
          </c:cat>
          <c:val>
            <c:numRef>
              <c:f>'Rapa (2)'!$Q$7:$R$7</c:f>
              <c:numCache>
                <c:formatCode>General</c:formatCode>
                <c:ptCount val="2"/>
                <c:pt idx="0">
                  <c:v>6.4600197407120374</c:v>
                </c:pt>
                <c:pt idx="1">
                  <c:v>6.21281714528317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84C-44B8-82D9-ACA5B6CF704C}"/>
            </c:ext>
          </c:extLst>
        </c:ser>
        <c:ser>
          <c:idx val="2"/>
          <c:order val="2"/>
          <c:tx>
            <c:strRef>
              <c:f>'Rapa (2)'!$P$8</c:f>
              <c:strCache>
                <c:ptCount val="1"/>
                <c:pt idx="0">
                  <c:v>A549-W + SB202190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apa (2)'!$Q$15:$T$15</c:f>
                <c:numCache>
                  <c:formatCode>General</c:formatCode>
                  <c:ptCount val="4"/>
                  <c:pt idx="0">
                    <c:v>1.9934341995134591E-2</c:v>
                  </c:pt>
                  <c:pt idx="1">
                    <c:v>1.029157759644768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apa (2)'!$Q$5:$R$5</c:f>
              <c:strCache>
                <c:ptCount val="2"/>
                <c:pt idx="0">
                  <c:v>BMP5</c:v>
                </c:pt>
                <c:pt idx="1">
                  <c:v>VCAM</c:v>
                </c:pt>
              </c:strCache>
            </c:strRef>
          </c:cat>
          <c:val>
            <c:numRef>
              <c:f>'Rapa (2)'!$Q$8:$R$8</c:f>
              <c:numCache>
                <c:formatCode>General</c:formatCode>
                <c:ptCount val="2"/>
                <c:pt idx="0">
                  <c:v>0.87048548815202131</c:v>
                </c:pt>
                <c:pt idx="1">
                  <c:v>0.912654265752180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84C-44B8-82D9-ACA5B6CF704C}"/>
            </c:ext>
          </c:extLst>
        </c:ser>
        <c:ser>
          <c:idx val="3"/>
          <c:order val="3"/>
          <c:tx>
            <c:strRef>
              <c:f>'Rapa (2)'!$P$9</c:f>
              <c:strCache>
                <c:ptCount val="1"/>
                <c:pt idx="0">
                  <c:v>A549-R + SB20219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apa (2)'!$Q$16:$T$16</c:f>
                <c:numCache>
                  <c:formatCode>General</c:formatCode>
                  <c:ptCount val="4"/>
                  <c:pt idx="0">
                    <c:v>9.2241325942721039E-2</c:v>
                  </c:pt>
                  <c:pt idx="1">
                    <c:v>0.210576847515245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apa (2)'!$Q$5:$R$5</c:f>
              <c:strCache>
                <c:ptCount val="2"/>
                <c:pt idx="0">
                  <c:v>BMP5</c:v>
                </c:pt>
                <c:pt idx="1">
                  <c:v>VCAM</c:v>
                </c:pt>
              </c:strCache>
            </c:strRef>
          </c:cat>
          <c:val>
            <c:numRef>
              <c:f>'Rapa (2)'!$Q$9:$R$9</c:f>
              <c:numCache>
                <c:formatCode>General</c:formatCode>
                <c:ptCount val="2"/>
                <c:pt idx="0">
                  <c:v>4.2784840203431509</c:v>
                </c:pt>
                <c:pt idx="1">
                  <c:v>6.41719879146897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84C-44B8-82D9-ACA5B6CF704C}"/>
            </c:ext>
          </c:extLst>
        </c:ser>
        <c:ser>
          <c:idx val="4"/>
          <c:order val="4"/>
          <c:tx>
            <c:strRef>
              <c:f>'Rapa (2)'!$P$10</c:f>
              <c:strCache>
                <c:ptCount val="1"/>
                <c:pt idx="0">
                  <c:v>A549-W + Rapamycin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apa (2)'!$Q$17:$T$17</c:f>
                <c:numCache>
                  <c:formatCode>General</c:formatCode>
                  <c:ptCount val="4"/>
                  <c:pt idx="0">
                    <c:v>1.257463123039349E-2</c:v>
                  </c:pt>
                  <c:pt idx="1">
                    <c:v>6.60423647936085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apa (2)'!$Q$5:$R$5</c:f>
              <c:strCache>
                <c:ptCount val="2"/>
                <c:pt idx="0">
                  <c:v>BMP5</c:v>
                </c:pt>
                <c:pt idx="1">
                  <c:v>VCAM</c:v>
                </c:pt>
              </c:strCache>
            </c:strRef>
          </c:cat>
          <c:val>
            <c:numRef>
              <c:f>'Rapa (2)'!$Q$10:$R$10</c:f>
              <c:numCache>
                <c:formatCode>General</c:formatCode>
                <c:ptCount val="2"/>
                <c:pt idx="0">
                  <c:v>0.9242016223304238</c:v>
                </c:pt>
                <c:pt idx="1">
                  <c:v>0.978119772979525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84C-44B8-82D9-ACA5B6CF704C}"/>
            </c:ext>
          </c:extLst>
        </c:ser>
        <c:ser>
          <c:idx val="5"/>
          <c:order val="5"/>
          <c:tx>
            <c:strRef>
              <c:f>'Rapa (2)'!$P$11</c:f>
              <c:strCache>
                <c:ptCount val="1"/>
                <c:pt idx="0">
                  <c:v>A549-R + Rapamycin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apa (2)'!$Q$18:$T$18</c:f>
                <c:numCache>
                  <c:formatCode>General</c:formatCode>
                  <c:ptCount val="4"/>
                  <c:pt idx="0">
                    <c:v>0.28528782822133236</c:v>
                  </c:pt>
                  <c:pt idx="1">
                    <c:v>0.433188630496967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apa (2)'!$Q$5:$R$5</c:f>
              <c:strCache>
                <c:ptCount val="2"/>
                <c:pt idx="0">
                  <c:v>BMP5</c:v>
                </c:pt>
                <c:pt idx="1">
                  <c:v>VCAM</c:v>
                </c:pt>
              </c:strCache>
            </c:strRef>
          </c:cat>
          <c:val>
            <c:numRef>
              <c:f>'Rapa (2)'!$Q$11:$R$11</c:f>
              <c:numCache>
                <c:formatCode>General</c:formatCode>
                <c:ptCount val="2"/>
                <c:pt idx="0">
                  <c:v>10.11750974294984</c:v>
                </c:pt>
                <c:pt idx="1">
                  <c:v>8.33579065439543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84C-44B8-82D9-ACA5B6CF70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97414144"/>
        <c:axId val="1197424960"/>
      </c:barChart>
      <c:catAx>
        <c:axId val="1197414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197424960"/>
        <c:crosses val="autoZero"/>
        <c:auto val="1"/>
        <c:lblAlgn val="ctr"/>
        <c:lblOffset val="100"/>
        <c:noMultiLvlLbl val="0"/>
      </c:catAx>
      <c:valAx>
        <c:axId val="1197424960"/>
        <c:scaling>
          <c:orientation val="minMax"/>
          <c:max val="1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197414144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3033193524945208"/>
          <c:y val="8.743472272734569E-2"/>
          <c:w val="0.34423361924434803"/>
          <c:h val="0.78080308933134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800"/>
              <a:t>ICAM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ICAM!$S$11:$S$12</c:f>
                <c:numCache>
                  <c:formatCode>General</c:formatCode>
                  <c:ptCount val="2"/>
                  <c:pt idx="0">
                    <c:v>0.35094032579598289</c:v>
                  </c:pt>
                  <c:pt idx="1">
                    <c:v>0.882154623035323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ICAM!$Q$11:$Q$12</c:f>
              <c:numCache>
                <c:formatCode>General</c:formatCode>
                <c:ptCount val="2"/>
              </c:numCache>
            </c:numRef>
          </c:cat>
          <c:val>
            <c:numRef>
              <c:f>ICAM!$R$11:$R$12</c:f>
              <c:numCache>
                <c:formatCode>General</c:formatCode>
                <c:ptCount val="2"/>
                <c:pt idx="0">
                  <c:v>1</c:v>
                </c:pt>
                <c:pt idx="1">
                  <c:v>2.48131304862777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ED-456B-9CD2-84542B2069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800"/>
              <a:t>Vimentin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Vimentin!$S$11:$S$12</c:f>
                <c:numCache>
                  <c:formatCode>General</c:formatCode>
                  <c:ptCount val="2"/>
                  <c:pt idx="0">
                    <c:v>0.13364781168979603</c:v>
                  </c:pt>
                  <c:pt idx="1">
                    <c:v>2.093258497330199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Vimentin!$Q$11:$Q$12</c:f>
              <c:numCache>
                <c:formatCode>General</c:formatCode>
                <c:ptCount val="2"/>
              </c:numCache>
            </c:numRef>
          </c:cat>
          <c:val>
            <c:numRef>
              <c:f>Vimentin!$R$11:$R$12</c:f>
              <c:numCache>
                <c:formatCode>General</c:formatCode>
                <c:ptCount val="2"/>
                <c:pt idx="0">
                  <c:v>1</c:v>
                </c:pt>
                <c:pt idx="1">
                  <c:v>1.27683752937862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09-4983-B345-3AEF1A3921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800"/>
              <a:t>E-Cadherin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-0Cadherin'!$S$11:$S$12</c:f>
                <c:numCache>
                  <c:formatCode>General</c:formatCode>
                  <c:ptCount val="2"/>
                  <c:pt idx="0">
                    <c:v>7.78277252587848E-2</c:v>
                  </c:pt>
                  <c:pt idx="1">
                    <c:v>3.485652158119517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E-0Cadherin'!$Q$11:$Q$12</c:f>
              <c:numCache>
                <c:formatCode>General</c:formatCode>
                <c:ptCount val="2"/>
              </c:numCache>
            </c:numRef>
          </c:cat>
          <c:val>
            <c:numRef>
              <c:f>'E-0Cadherin'!$R$11:$R$12</c:f>
              <c:numCache>
                <c:formatCode>General</c:formatCode>
                <c:ptCount val="2"/>
                <c:pt idx="0">
                  <c:v>1</c:v>
                </c:pt>
                <c:pt idx="1">
                  <c:v>1.07054426475839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7C-4048-8309-5E11D06494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ell cycle'!$P$6</c:f>
              <c:strCache>
                <c:ptCount val="1"/>
                <c:pt idx="0">
                  <c:v>A549-W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ell cycle'!$Q$11:$Y$11</c:f>
                <c:numCache>
                  <c:formatCode>General</c:formatCode>
                  <c:ptCount val="9"/>
                  <c:pt idx="0">
                    <c:v>2.9964750684022001E-2</c:v>
                  </c:pt>
                  <c:pt idx="1">
                    <c:v>4.7369392688173056E-2</c:v>
                  </c:pt>
                  <c:pt idx="2">
                    <c:v>5.0949669220353169E-2</c:v>
                  </c:pt>
                  <c:pt idx="3">
                    <c:v>5.9378233652626136E-2</c:v>
                  </c:pt>
                  <c:pt idx="4">
                    <c:v>4.8201077082145542E-2</c:v>
                  </c:pt>
                  <c:pt idx="5">
                    <c:v>0.10848958363212002</c:v>
                  </c:pt>
                  <c:pt idx="6">
                    <c:v>0.10115008059306216</c:v>
                  </c:pt>
                  <c:pt idx="7">
                    <c:v>1.442436462501317E-2</c:v>
                  </c:pt>
                  <c:pt idx="8">
                    <c:v>1.59959039468781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Cell cycle'!$Q$5:$X$5</c:f>
              <c:strCache>
                <c:ptCount val="8"/>
                <c:pt idx="0">
                  <c:v>p21</c:v>
                </c:pt>
                <c:pt idx="1">
                  <c:v>CDK2</c:v>
                </c:pt>
                <c:pt idx="2">
                  <c:v>CDC25A</c:v>
                </c:pt>
                <c:pt idx="3">
                  <c:v>Cyclin D1</c:v>
                </c:pt>
                <c:pt idx="4">
                  <c:v>CDK4</c:v>
                </c:pt>
                <c:pt idx="5">
                  <c:v>CDC14A</c:v>
                </c:pt>
                <c:pt idx="6">
                  <c:v>CDK6</c:v>
                </c:pt>
                <c:pt idx="7">
                  <c:v>Cyclin E1</c:v>
                </c:pt>
              </c:strCache>
            </c:strRef>
          </c:cat>
          <c:val>
            <c:numRef>
              <c:f>'Cell cycle'!$Q$6:$X$6</c:f>
              <c:numCache>
                <c:formatCode>General</c:formatCode>
                <c:ptCount val="8"/>
                <c:pt idx="0">
                  <c:v>1.0008897046917291</c:v>
                </c:pt>
                <c:pt idx="1">
                  <c:v>1.002202965435232</c:v>
                </c:pt>
                <c:pt idx="2">
                  <c:v>1.0025129698444679</c:v>
                </c:pt>
                <c:pt idx="3">
                  <c:v>1.0033943996437833</c:v>
                </c:pt>
                <c:pt idx="4">
                  <c:v>1.0023923916114619</c:v>
                </c:pt>
                <c:pt idx="5">
                  <c:v>1.0125991828797449</c:v>
                </c:pt>
                <c:pt idx="6">
                  <c:v>1.0106046370571891</c:v>
                </c:pt>
                <c:pt idx="7">
                  <c:v>1.00020713062682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02-4177-8227-1DE13CB8D338}"/>
            </c:ext>
          </c:extLst>
        </c:ser>
        <c:ser>
          <c:idx val="1"/>
          <c:order val="1"/>
          <c:tx>
            <c:strRef>
              <c:f>'Cell cycle'!$P$7</c:f>
              <c:strCache>
                <c:ptCount val="1"/>
                <c:pt idx="0">
                  <c:v>A549-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ell cycle'!$Q$12:$X$12</c:f>
                <c:numCache>
                  <c:formatCode>General</c:formatCode>
                  <c:ptCount val="8"/>
                  <c:pt idx="0">
                    <c:v>3.3618389392126351E-2</c:v>
                  </c:pt>
                  <c:pt idx="1">
                    <c:v>1.7592412454802652E-2</c:v>
                  </c:pt>
                  <c:pt idx="2">
                    <c:v>0.16191944379289161</c:v>
                  </c:pt>
                  <c:pt idx="3">
                    <c:v>7.8381085298633704E-2</c:v>
                  </c:pt>
                  <c:pt idx="4">
                    <c:v>4.2065529103752983E-2</c:v>
                  </c:pt>
                  <c:pt idx="5">
                    <c:v>0.10590123359044039</c:v>
                  </c:pt>
                  <c:pt idx="6">
                    <c:v>5.4206909362630945E-3</c:v>
                  </c:pt>
                  <c:pt idx="7">
                    <c:v>7.787959744669778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Cell cycle'!$Q$5:$X$5</c:f>
              <c:strCache>
                <c:ptCount val="8"/>
                <c:pt idx="0">
                  <c:v>p21</c:v>
                </c:pt>
                <c:pt idx="1">
                  <c:v>CDK2</c:v>
                </c:pt>
                <c:pt idx="2">
                  <c:v>CDC25A</c:v>
                </c:pt>
                <c:pt idx="3">
                  <c:v>Cyclin D1</c:v>
                </c:pt>
                <c:pt idx="4">
                  <c:v>CDK4</c:v>
                </c:pt>
                <c:pt idx="5">
                  <c:v>CDC14A</c:v>
                </c:pt>
                <c:pt idx="6">
                  <c:v>CDK6</c:v>
                </c:pt>
                <c:pt idx="7">
                  <c:v>Cyclin E1</c:v>
                </c:pt>
              </c:strCache>
            </c:strRef>
          </c:cat>
          <c:val>
            <c:numRef>
              <c:f>'Cell cycle'!$Q$7:$X$7</c:f>
              <c:numCache>
                <c:formatCode>General</c:formatCode>
                <c:ptCount val="8"/>
                <c:pt idx="0">
                  <c:v>1.3447025550802867</c:v>
                </c:pt>
                <c:pt idx="1">
                  <c:v>1.1560230461903005</c:v>
                </c:pt>
                <c:pt idx="2">
                  <c:v>1.3507642741686681</c:v>
                </c:pt>
                <c:pt idx="3">
                  <c:v>1.370896646700384</c:v>
                </c:pt>
                <c:pt idx="4">
                  <c:v>1.1424171367658822</c:v>
                </c:pt>
                <c:pt idx="5">
                  <c:v>1.1408410314289186</c:v>
                </c:pt>
                <c:pt idx="6">
                  <c:v>0.7676093209533571</c:v>
                </c:pt>
                <c:pt idx="7">
                  <c:v>1.3027032237667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02-4177-8227-1DE13CB8D3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97414144"/>
        <c:axId val="1197424960"/>
      </c:barChart>
      <c:catAx>
        <c:axId val="1197414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197424960"/>
        <c:crosses val="autoZero"/>
        <c:auto val="1"/>
        <c:lblAlgn val="ctr"/>
        <c:lblOffset val="100"/>
        <c:noMultiLvlLbl val="0"/>
      </c:catAx>
      <c:valAx>
        <c:axId val="1197424960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19741414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tr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</c:legendEntry>
      <c:layout>
        <c:manualLayout>
          <c:xMode val="edge"/>
          <c:yMode val="edge"/>
          <c:x val="0.84955193675428953"/>
          <c:y val="5.1342592592592606E-2"/>
          <c:w val="0.14279082859548611"/>
          <c:h val="0.24581888888888889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3K27me3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1]H3K27me3!$S$11:$S$14</c:f>
                <c:numCache>
                  <c:formatCode>General</c:formatCode>
                  <c:ptCount val="4"/>
                  <c:pt idx="0">
                    <c:v>0.11824698359416168</c:v>
                  </c:pt>
                  <c:pt idx="1">
                    <c:v>4.9033241273424392E-2</c:v>
                  </c:pt>
                  <c:pt idx="2">
                    <c:v>0.1067583979426748</c:v>
                  </c:pt>
                  <c:pt idx="3">
                    <c:v>6.197327999634705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[1]H3K27me3!$Q$3:$Q$6</c:f>
              <c:numCache>
                <c:formatCode>General</c:formatCode>
                <c:ptCount val="4"/>
              </c:numCache>
            </c:numRef>
          </c:cat>
          <c:val>
            <c:numRef>
              <c:f>[1]H3K27me3!$R$11:$R$14</c:f>
              <c:numCache>
                <c:formatCode>General</c:formatCode>
                <c:ptCount val="4"/>
                <c:pt idx="0">
                  <c:v>0.99999999999999989</c:v>
                </c:pt>
                <c:pt idx="1">
                  <c:v>0.9414753217631886</c:v>
                </c:pt>
                <c:pt idx="2">
                  <c:v>0.8449619966495806</c:v>
                </c:pt>
                <c:pt idx="3">
                  <c:v>0.483534889652889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7F-4BC6-A46C-B81330351E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3K4me1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-p38 MAPK'!$S$11:$S$14</c:f>
                <c:numCache>
                  <c:formatCode>General</c:formatCode>
                  <c:ptCount val="4"/>
                  <c:pt idx="0">
                    <c:v>0.17703549840227992</c:v>
                  </c:pt>
                  <c:pt idx="1">
                    <c:v>0.49992434904466643</c:v>
                  </c:pt>
                  <c:pt idx="2">
                    <c:v>0.30288561889344201</c:v>
                  </c:pt>
                  <c:pt idx="3">
                    <c:v>0.241018458098770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-p38 MAPK'!$Q$3:$Q$6</c:f>
              <c:numCache>
                <c:formatCode>General</c:formatCode>
                <c:ptCount val="4"/>
              </c:numCache>
            </c:numRef>
          </c:cat>
          <c:val>
            <c:numRef>
              <c:f>'p-p38 MAPK'!$R$11:$R$14</c:f>
              <c:numCache>
                <c:formatCode>General</c:formatCode>
                <c:ptCount val="4"/>
                <c:pt idx="0">
                  <c:v>1</c:v>
                </c:pt>
                <c:pt idx="1">
                  <c:v>3.0478184359541731</c:v>
                </c:pt>
                <c:pt idx="2">
                  <c:v>0.97332259529520648</c:v>
                </c:pt>
                <c:pt idx="3">
                  <c:v>1.52599441385406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93-493A-BD3E-C83F484CD6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H3K27ac</a:t>
            </a:r>
            <a:endParaRPr lang="ko-KR" sz="8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3K27ac!$S$11:$S$14</c:f>
                <c:numCache>
                  <c:formatCode>General</c:formatCode>
                  <c:ptCount val="4"/>
                  <c:pt idx="0">
                    <c:v>0.20124153366840875</c:v>
                  </c:pt>
                  <c:pt idx="1">
                    <c:v>0.21092763494745218</c:v>
                  </c:pt>
                  <c:pt idx="2">
                    <c:v>0.14304931249428884</c:v>
                  </c:pt>
                  <c:pt idx="3">
                    <c:v>6.492211930759125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3K27ac!$Q$3:$Q$6</c:f>
              <c:numCache>
                <c:formatCode>General</c:formatCode>
                <c:ptCount val="4"/>
              </c:numCache>
            </c:numRef>
          </c:cat>
          <c:val>
            <c:numRef>
              <c:f>H3K27ac!$R$11:$R$14</c:f>
              <c:numCache>
                <c:formatCode>General</c:formatCode>
                <c:ptCount val="4"/>
                <c:pt idx="0">
                  <c:v>1</c:v>
                </c:pt>
                <c:pt idx="1">
                  <c:v>0.85427669344381096</c:v>
                </c:pt>
                <c:pt idx="2">
                  <c:v>0.63684402968691611</c:v>
                </c:pt>
                <c:pt idx="3">
                  <c:v>0.69601585853089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07-49A8-A66C-E50C676FCC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05320975"/>
        <c:axId val="1805317615"/>
      </c:barChart>
      <c:catAx>
        <c:axId val="1805320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17615"/>
        <c:crosses val="autoZero"/>
        <c:auto val="1"/>
        <c:lblAlgn val="ctr"/>
        <c:lblOffset val="100"/>
        <c:noMultiLvlLbl val="0"/>
      </c:catAx>
      <c:valAx>
        <c:axId val="1805317615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805320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85558" cy="502835"/>
          </a:xfrm>
          <a:prstGeom prst="rect">
            <a:avLst/>
          </a:prstGeom>
        </p:spPr>
        <p:txBody>
          <a:bodyPr vert="horz" lIns="92445" tIns="46223" rIns="92445" bIns="46223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598" y="2"/>
            <a:ext cx="2985558" cy="502835"/>
          </a:xfrm>
          <a:prstGeom prst="rect">
            <a:avLst/>
          </a:prstGeom>
        </p:spPr>
        <p:txBody>
          <a:bodyPr vert="horz" lIns="92445" tIns="46223" rIns="92445" bIns="46223" rtlCol="0"/>
          <a:lstStyle>
            <a:lvl1pPr algn="r">
              <a:defRPr sz="1200"/>
            </a:lvl1pPr>
          </a:lstStyle>
          <a:p>
            <a:fld id="{CBCB6560-B482-49B5-B079-A4E4ACC3D77A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4125"/>
            <a:ext cx="2536825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5" tIns="46223" rIns="92445" bIns="46223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6" y="4823033"/>
            <a:ext cx="5511800" cy="3946119"/>
          </a:xfrm>
          <a:prstGeom prst="rect">
            <a:avLst/>
          </a:prstGeom>
        </p:spPr>
        <p:txBody>
          <a:bodyPr vert="horz" lIns="92445" tIns="46223" rIns="92445" bIns="46223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9057"/>
            <a:ext cx="2985558" cy="502834"/>
          </a:xfrm>
          <a:prstGeom prst="rect">
            <a:avLst/>
          </a:prstGeom>
        </p:spPr>
        <p:txBody>
          <a:bodyPr vert="horz" lIns="92445" tIns="46223" rIns="92445" bIns="46223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598" y="9519057"/>
            <a:ext cx="2985558" cy="502834"/>
          </a:xfrm>
          <a:prstGeom prst="rect">
            <a:avLst/>
          </a:prstGeom>
        </p:spPr>
        <p:txBody>
          <a:bodyPr vert="horz" lIns="92445" tIns="46223" rIns="92445" bIns="46223" rtlCol="0" anchor="b"/>
          <a:lstStyle>
            <a:lvl1pPr algn="r">
              <a:defRPr sz="1200"/>
            </a:lvl1pPr>
          </a:lstStyle>
          <a:p>
            <a:fld id="{4D4C27B3-8C21-49AB-BA91-C995589261D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57086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686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5920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0865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7522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0667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922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0513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9517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0095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9811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2947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59CD0-660D-46B6-A23F-DA01DCF87FB2}" type="datetimeFigureOut">
              <a:rPr lang="ko-KR" altLang="en-US" smtClean="0"/>
              <a:t>2023-04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B17195-901E-4E0F-92E1-3DFD4EE72E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448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0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7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6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7" Type="http://schemas.openxmlformats.org/officeDocument/2006/relationships/image" Target="../media/image23.emf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3.xml"/><Relationship Id="rId13" Type="http://schemas.openxmlformats.org/officeDocument/2006/relationships/chart" Target="../charts/chart18.xml"/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12" Type="http://schemas.openxmlformats.org/officeDocument/2006/relationships/chart" Target="../charts/chart17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11" Type="http://schemas.openxmlformats.org/officeDocument/2006/relationships/chart" Target="../charts/chart16.xml"/><Relationship Id="rId5" Type="http://schemas.openxmlformats.org/officeDocument/2006/relationships/chart" Target="../charts/chart10.xml"/><Relationship Id="rId10" Type="http://schemas.openxmlformats.org/officeDocument/2006/relationships/chart" Target="../charts/chart15.xml"/><Relationship Id="rId4" Type="http://schemas.openxmlformats.org/officeDocument/2006/relationships/chart" Target="../charts/chart9.xml"/><Relationship Id="rId9" Type="http://schemas.openxmlformats.org/officeDocument/2006/relationships/chart" Target="../charts/chart14.xml"/><Relationship Id="rId14" Type="http://schemas.openxmlformats.org/officeDocument/2006/relationships/chart" Target="../charts/chart1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EC3132D-CCCB-E643-A36D-D4CE942EACEB}"/>
              </a:ext>
            </a:extLst>
          </p:cNvPr>
          <p:cNvSpPr txBox="1"/>
          <p:nvPr/>
        </p:nvSpPr>
        <p:spPr>
          <a:xfrm>
            <a:off x="-12700" y="878562"/>
            <a:ext cx="5421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53012DC-BC66-CF76-16D4-227DB923246A}"/>
              </a:ext>
            </a:extLst>
          </p:cNvPr>
          <p:cNvSpPr txBox="1"/>
          <p:nvPr/>
        </p:nvSpPr>
        <p:spPr>
          <a:xfrm>
            <a:off x="-12700" y="7759700"/>
            <a:ext cx="68707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1. Establishment of metformin-resistant A549 human lung cancer cells (A549-R cells) </a:t>
            </a:r>
            <a:endParaRPr lang="ko-KR" altLang="en-US" sz="1200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1CBF06B1-A4E6-ABB3-8A36-2100397847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998" y="1107301"/>
            <a:ext cx="3281857" cy="2520000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EF051CFA-1AE1-7B8A-45CD-45038F1757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2650" y="1107301"/>
            <a:ext cx="3281857" cy="252000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0CC48934-0A74-078D-F3B1-305FB22307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999" y="4256700"/>
            <a:ext cx="3281857" cy="252000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BB7D4BE0-FC9D-E5D1-55F7-9E1A8FAB3D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2650" y="4256700"/>
            <a:ext cx="3281857" cy="2520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5BF6120-77B3-B86C-5263-A95109400C95}"/>
              </a:ext>
            </a:extLst>
          </p:cNvPr>
          <p:cNvSpPr txBox="1"/>
          <p:nvPr/>
        </p:nvSpPr>
        <p:spPr>
          <a:xfrm>
            <a:off x="0" y="3953048"/>
            <a:ext cx="5421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96 h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91230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차트 2">
            <a:extLst>
              <a:ext uri="{FF2B5EF4-FFF2-40B4-BE49-F238E27FC236}">
                <a16:creationId xmlns:a16="http://schemas.microsoft.com/office/drawing/2014/main" id="{E99EAC8B-1BCD-4A46-9B66-2C0857F8FD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9370402"/>
              </p:ext>
            </p:extLst>
          </p:nvPr>
        </p:nvGraphicFramePr>
        <p:xfrm>
          <a:off x="1846740" y="3855728"/>
          <a:ext cx="3495260" cy="14325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9DE19C5-8C98-D49B-DBEE-2D5035AD0EF4}"/>
              </a:ext>
            </a:extLst>
          </p:cNvPr>
          <p:cNvSpPr txBox="1"/>
          <p:nvPr/>
        </p:nvSpPr>
        <p:spPr>
          <a:xfrm rot="16200000">
            <a:off x="1255873" y="4407453"/>
            <a:ext cx="1181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Relative mRNA level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6F80AA-C7F1-6D94-CF1A-F547FA6344F3}"/>
              </a:ext>
            </a:extLst>
          </p:cNvPr>
          <p:cNvSpPr txBox="1"/>
          <p:nvPr/>
        </p:nvSpPr>
        <p:spPr>
          <a:xfrm>
            <a:off x="2199852" y="4164777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8A6A5696-12A5-4CA0-9821-6D20A6B31B72}"/>
              </a:ext>
            </a:extLst>
          </p:cNvPr>
          <p:cNvCxnSpPr/>
          <p:nvPr/>
        </p:nvCxnSpPr>
        <p:spPr>
          <a:xfrm>
            <a:off x="2257085" y="4297671"/>
            <a:ext cx="14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13959659-9FE6-7A56-3D59-239B4E3B6AF1}"/>
              </a:ext>
            </a:extLst>
          </p:cNvPr>
          <p:cNvSpPr txBox="1"/>
          <p:nvPr/>
        </p:nvSpPr>
        <p:spPr>
          <a:xfrm>
            <a:off x="2401085" y="4231452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BFFAB6F1-1918-AB9E-721E-BA42B90EA6F8}"/>
              </a:ext>
            </a:extLst>
          </p:cNvPr>
          <p:cNvCxnSpPr/>
          <p:nvPr/>
        </p:nvCxnSpPr>
        <p:spPr>
          <a:xfrm>
            <a:off x="2383143" y="4367521"/>
            <a:ext cx="25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60928491-CF1D-19ED-0074-275CD576CF2F}"/>
              </a:ext>
            </a:extLst>
          </p:cNvPr>
          <p:cNvSpPr txBox="1"/>
          <p:nvPr/>
        </p:nvSpPr>
        <p:spPr>
          <a:xfrm>
            <a:off x="2499977" y="3924307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99DB0436-FFB6-E4DA-6BA7-EC5F8FC61C75}"/>
              </a:ext>
            </a:extLst>
          </p:cNvPr>
          <p:cNvCxnSpPr/>
          <p:nvPr/>
        </p:nvCxnSpPr>
        <p:spPr>
          <a:xfrm>
            <a:off x="2371385" y="4066947"/>
            <a:ext cx="52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AE099D22-8CAD-5CE7-393F-310770FEFA6C}"/>
              </a:ext>
            </a:extLst>
          </p:cNvPr>
          <p:cNvSpPr txBox="1"/>
          <p:nvPr/>
        </p:nvSpPr>
        <p:spPr>
          <a:xfrm>
            <a:off x="3416605" y="4066947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9EE0961F-CC19-07E0-CAEE-AEF648FD9E33}"/>
              </a:ext>
            </a:extLst>
          </p:cNvPr>
          <p:cNvCxnSpPr/>
          <p:nvPr/>
        </p:nvCxnSpPr>
        <p:spPr>
          <a:xfrm>
            <a:off x="3268963" y="4209587"/>
            <a:ext cx="52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7A72BA4F-D067-AF60-CE8F-9229CBC26590}"/>
              </a:ext>
            </a:extLst>
          </p:cNvPr>
          <p:cNvSpPr txBox="1"/>
          <p:nvPr/>
        </p:nvSpPr>
        <p:spPr>
          <a:xfrm>
            <a:off x="3102912" y="4272499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694B3405-C0D0-EF78-3D9D-0F3A4FA6331A}"/>
              </a:ext>
            </a:extLst>
          </p:cNvPr>
          <p:cNvCxnSpPr/>
          <p:nvPr/>
        </p:nvCxnSpPr>
        <p:spPr>
          <a:xfrm>
            <a:off x="3160145" y="4405393"/>
            <a:ext cx="14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4B5EBBAC-30A6-0D09-5E47-346D7A8F85A5}"/>
              </a:ext>
            </a:extLst>
          </p:cNvPr>
          <p:cNvSpPr txBox="1"/>
          <p:nvPr/>
        </p:nvSpPr>
        <p:spPr>
          <a:xfrm>
            <a:off x="-67622" y="5705042"/>
            <a:ext cx="68707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10. p38 MAPK inhibitor, but not rapamycin, attenuated up-regulation of VCAM gene by metformin-resistance 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9696401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2487D9B6-D364-3368-0B07-8A2E10BF626D}"/>
              </a:ext>
            </a:extLst>
          </p:cNvPr>
          <p:cNvSpPr txBox="1"/>
          <p:nvPr/>
        </p:nvSpPr>
        <p:spPr>
          <a:xfrm>
            <a:off x="-12700" y="2446894"/>
            <a:ext cx="5421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48 h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D1B8E3D0-8009-C157-2864-5E12AAB6A0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073" y="3280700"/>
            <a:ext cx="3288814" cy="2520000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9FCC8515-3F07-F059-D1A4-FD2EAD76E6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3208982"/>
            <a:ext cx="3288814" cy="252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A3589B6-1A92-CAEC-5654-440DA7202B88}"/>
              </a:ext>
            </a:extLst>
          </p:cNvPr>
          <p:cNvSpPr txBox="1"/>
          <p:nvPr/>
        </p:nvSpPr>
        <p:spPr>
          <a:xfrm>
            <a:off x="-12700" y="7759700"/>
            <a:ext cx="68707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2. A549-R cells did not show cross-resistance to gefitinib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059598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EC3132D-CCCB-E643-A36D-D4CE942EACEB}"/>
              </a:ext>
            </a:extLst>
          </p:cNvPr>
          <p:cNvSpPr txBox="1"/>
          <p:nvPr/>
        </p:nvSpPr>
        <p:spPr>
          <a:xfrm>
            <a:off x="0" y="504789"/>
            <a:ext cx="5421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48 h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F64DBD9C-C210-ECA7-4AD7-149E7A88ED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0879" y="3955125"/>
            <a:ext cx="3239250" cy="2520000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B8D7DE57-21A3-1575-471A-55D5DF36FB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3955125"/>
            <a:ext cx="3134762" cy="252000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51C93DFE-7A22-26F1-9E1E-68CDDCBCA2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5194" y="751010"/>
            <a:ext cx="3274935" cy="2520000"/>
          </a:xfrm>
          <a:prstGeom prst="rect">
            <a:avLst/>
          </a:prstGeom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5FF3537C-C6A9-82F5-B619-5C4C3AF067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2650" y="751010"/>
            <a:ext cx="3281857" cy="2520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9659F17-317B-02B9-E2A4-096C3F6F2BA4}"/>
              </a:ext>
            </a:extLst>
          </p:cNvPr>
          <p:cNvSpPr txBox="1"/>
          <p:nvPr/>
        </p:nvSpPr>
        <p:spPr>
          <a:xfrm>
            <a:off x="-12700" y="7759700"/>
            <a:ext cx="68707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3. Cell viability of representative cancer cell lines to metformin treatment 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5068360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EB95DD14-E708-451F-24E2-666AC6E290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450" y="1695450"/>
            <a:ext cx="5753100" cy="57531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8B46C79-0A28-B897-0B9E-D194EEB6CF0F}"/>
              </a:ext>
            </a:extLst>
          </p:cNvPr>
          <p:cNvSpPr txBox="1"/>
          <p:nvPr/>
        </p:nvSpPr>
        <p:spPr>
          <a:xfrm>
            <a:off x="-12700" y="7759700"/>
            <a:ext cx="68707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4. </a:t>
            </a:r>
            <a:r>
              <a:rPr lang="en-US" altLang="ko-KR" sz="1200" b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굴림" panose="020B0600000101010101" pitchFamily="50" charset="-127"/>
              </a:rPr>
              <a:t>Inter-sample correlation heat map of A549-R cells upon metformin treatment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7093317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1B03D1B-CB7E-BC94-FD1C-CD383847AD2B}"/>
              </a:ext>
            </a:extLst>
          </p:cNvPr>
          <p:cNvSpPr txBox="1"/>
          <p:nvPr/>
        </p:nvSpPr>
        <p:spPr>
          <a:xfrm>
            <a:off x="-12700" y="7759700"/>
            <a:ext cx="68707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5. Gene ontology analysis of A549-R cells upon metformin treatment</a:t>
            </a:r>
            <a:endParaRPr lang="ko-KR" altLang="en-US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7E0C368-F9E9-CB6B-36B8-EDCA5AFCC295}"/>
              </a:ext>
            </a:extLst>
          </p:cNvPr>
          <p:cNvSpPr txBox="1"/>
          <p:nvPr/>
        </p:nvSpPr>
        <p:spPr>
          <a:xfrm>
            <a:off x="21529" y="148403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43EB4BB-2DA9-38D4-8526-AE5D93C1BD84}"/>
              </a:ext>
            </a:extLst>
          </p:cNvPr>
          <p:cNvSpPr txBox="1"/>
          <p:nvPr/>
        </p:nvSpPr>
        <p:spPr>
          <a:xfrm>
            <a:off x="416359" y="1812079"/>
            <a:ext cx="30130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O dot plot (A549R_Con vs A549W_Con; up-regulated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C1BDF77-3342-E5D0-59E9-CD31F13E80D9}"/>
              </a:ext>
            </a:extLst>
          </p:cNvPr>
          <p:cNvSpPr txBox="1"/>
          <p:nvPr/>
        </p:nvSpPr>
        <p:spPr>
          <a:xfrm>
            <a:off x="372907" y="4517296"/>
            <a:ext cx="30130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O dot plot (A549R_Con vs A549W_Con; down-regulated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FD94552-1068-6D84-F7C3-044E584EEB26}"/>
              </a:ext>
            </a:extLst>
          </p:cNvPr>
          <p:cNvSpPr txBox="1"/>
          <p:nvPr/>
        </p:nvSpPr>
        <p:spPr>
          <a:xfrm>
            <a:off x="3844938" y="1822292"/>
            <a:ext cx="30130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O dot plot (A549R_Met vs A549W_Met; up-regulated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76125D2-E30E-1CA1-D93B-DD1EE234CA47}"/>
              </a:ext>
            </a:extLst>
          </p:cNvPr>
          <p:cNvSpPr txBox="1"/>
          <p:nvPr/>
        </p:nvSpPr>
        <p:spPr>
          <a:xfrm>
            <a:off x="3723435" y="4517296"/>
            <a:ext cx="30130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O dot plot (A549R_Met vs A549W_Met; down-regulated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그림 14">
            <a:extLst>
              <a:ext uri="{FF2B5EF4-FFF2-40B4-BE49-F238E27FC236}">
                <a16:creationId xmlns:a16="http://schemas.microsoft.com/office/drawing/2014/main" id="{22C20A50-F6B0-A165-ED12-B58A4BBE8B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8330" y="2178749"/>
            <a:ext cx="2160000" cy="2160000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763B301F-74D1-ED06-D5A0-21D38BED51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330" y="4911287"/>
            <a:ext cx="2168035" cy="216000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693C5AED-154E-B9C9-E847-BAF4A5B9E9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82486" y="2218155"/>
            <a:ext cx="2157184" cy="2160000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45DA7BEF-D6B9-60F8-D59C-C417F6CC4F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71637" y="4911287"/>
            <a:ext cx="2157184" cy="2160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6D670A5-8FBD-F142-2637-2E66B2A1CA60}"/>
              </a:ext>
            </a:extLst>
          </p:cNvPr>
          <p:cNvSpPr txBox="1"/>
          <p:nvPr/>
        </p:nvSpPr>
        <p:spPr>
          <a:xfrm>
            <a:off x="3547746" y="148403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54528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08AD643-1FB1-895D-0E8A-7D4C7B31130A}"/>
              </a:ext>
            </a:extLst>
          </p:cNvPr>
          <p:cNvSpPr txBox="1"/>
          <p:nvPr/>
        </p:nvSpPr>
        <p:spPr>
          <a:xfrm>
            <a:off x="-12700" y="7945398"/>
            <a:ext cx="68707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6. Representative FPKM values of epigenetic modifying enzyme and ABCB genes in A549-R cells upon metformin treatment</a:t>
            </a:r>
            <a:endParaRPr lang="ko-KR" altLang="en-US" sz="1200" dirty="0"/>
          </a:p>
        </p:txBody>
      </p:sp>
      <p:graphicFrame>
        <p:nvGraphicFramePr>
          <p:cNvPr id="3" name="개체 2">
            <a:extLst>
              <a:ext uri="{FF2B5EF4-FFF2-40B4-BE49-F238E27FC236}">
                <a16:creationId xmlns:a16="http://schemas.microsoft.com/office/drawing/2014/main" id="{C2A23150-97B8-FF95-DB64-68799D5D21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8993103"/>
              </p:ext>
            </p:extLst>
          </p:nvPr>
        </p:nvGraphicFramePr>
        <p:xfrm>
          <a:off x="779346" y="966828"/>
          <a:ext cx="5299308" cy="2319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Project" r:id="rId3" imgW="6912000" imgH="2808000" progId="Prism5.Document">
                  <p:embed/>
                </p:oleObj>
              </mc:Choice>
              <mc:Fallback>
                <p:oleObj name="Prism Project" r:id="rId3" imgW="6912000" imgH="2808000" progId="Prism5.Document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C2A23150-97B8-FF95-DB64-68799D5D219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79346" y="966828"/>
                        <a:ext cx="5299308" cy="2319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2023CAE9-892A-9ADC-E67C-0022E3DAF1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4679617"/>
              </p:ext>
            </p:extLst>
          </p:nvPr>
        </p:nvGraphicFramePr>
        <p:xfrm>
          <a:off x="875357" y="2567596"/>
          <a:ext cx="4561739" cy="3092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Project" r:id="rId5" imgW="5940000" imgH="3744000" progId="Prism5.Document">
                  <p:embed/>
                </p:oleObj>
              </mc:Choice>
              <mc:Fallback>
                <p:oleObj name="Prism Project" r:id="rId5" imgW="5940000" imgH="3744000" progId="Prism5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2023CAE9-892A-9ADC-E67C-0022E3DAF1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75357" y="2567596"/>
                        <a:ext cx="4561739" cy="3092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98660AB6-A689-0804-9E48-B25F6901BB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5895198"/>
              </p:ext>
            </p:extLst>
          </p:nvPr>
        </p:nvGraphicFramePr>
        <p:xfrm>
          <a:off x="865096" y="5290179"/>
          <a:ext cx="4572000" cy="2319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Project" r:id="rId7" imgW="5940000" imgH="2808000" progId="Prism5.Document">
                  <p:embed/>
                </p:oleObj>
              </mc:Choice>
              <mc:Fallback>
                <p:oleObj name="Prism Project" r:id="rId7" imgW="5940000" imgH="2808000" progId="Prism5.Document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98660AB6-A689-0804-9E48-B25F6901BB9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65096" y="5290179"/>
                        <a:ext cx="4572000" cy="2319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423877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>
            <a:extLst>
              <a:ext uri="{FF2B5EF4-FFF2-40B4-BE49-F238E27FC236}">
                <a16:creationId xmlns:a16="http://schemas.microsoft.com/office/drawing/2014/main" id="{A2A41D36-DBC9-112D-2F1F-0729FDC279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7680954"/>
              </p:ext>
            </p:extLst>
          </p:nvPr>
        </p:nvGraphicFramePr>
        <p:xfrm>
          <a:off x="910038" y="2534448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B68DD83-975C-B88D-B8DA-B46C4227E754}"/>
              </a:ext>
            </a:extLst>
          </p:cNvPr>
          <p:cNvSpPr txBox="1"/>
          <p:nvPr/>
        </p:nvSpPr>
        <p:spPr>
          <a:xfrm>
            <a:off x="1117515" y="4082932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1E5A882-BBE3-1891-A76D-0B61D05DE6A5}"/>
              </a:ext>
            </a:extLst>
          </p:cNvPr>
          <p:cNvSpPr txBox="1"/>
          <p:nvPr/>
        </p:nvSpPr>
        <p:spPr>
          <a:xfrm>
            <a:off x="1549007" y="4082932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BC3FC99-57CE-63BF-7AE9-99C651C87B56}"/>
              </a:ext>
            </a:extLst>
          </p:cNvPr>
          <p:cNvSpPr txBox="1"/>
          <p:nvPr/>
        </p:nvSpPr>
        <p:spPr>
          <a:xfrm rot="16200000">
            <a:off x="355780" y="3381493"/>
            <a:ext cx="10390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VCAM1 / 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11B30A1-A9F2-A2A7-1CFD-282B7C0C097F}"/>
              </a:ext>
            </a:extLst>
          </p:cNvPr>
          <p:cNvSpPr txBox="1"/>
          <p:nvPr/>
        </p:nvSpPr>
        <p:spPr>
          <a:xfrm>
            <a:off x="1685996" y="2804085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52657BC-26E6-43A0-7E0A-BE8E258490BC}"/>
              </a:ext>
            </a:extLst>
          </p:cNvPr>
          <p:cNvSpPr txBox="1"/>
          <p:nvPr/>
        </p:nvSpPr>
        <p:spPr>
          <a:xfrm>
            <a:off x="2952588" y="4082932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99C1E4D-8428-E36E-CF51-EEDE72A8B25A}"/>
              </a:ext>
            </a:extLst>
          </p:cNvPr>
          <p:cNvSpPr txBox="1"/>
          <p:nvPr/>
        </p:nvSpPr>
        <p:spPr>
          <a:xfrm>
            <a:off x="3384080" y="4082932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95642A1-5C13-F86B-1980-A011937E3E9D}"/>
              </a:ext>
            </a:extLst>
          </p:cNvPr>
          <p:cNvSpPr txBox="1"/>
          <p:nvPr/>
        </p:nvSpPr>
        <p:spPr>
          <a:xfrm rot="16200000">
            <a:off x="2205280" y="3381493"/>
            <a:ext cx="10102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MP-2 / 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06A95B8-01DD-41C7-ACF3-A070907CCE6E}"/>
              </a:ext>
            </a:extLst>
          </p:cNvPr>
          <p:cNvSpPr txBox="1"/>
          <p:nvPr/>
        </p:nvSpPr>
        <p:spPr>
          <a:xfrm>
            <a:off x="3521069" y="2804085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6519939-69F4-BCF7-BB1A-24930D447819}"/>
              </a:ext>
            </a:extLst>
          </p:cNvPr>
          <p:cNvSpPr txBox="1"/>
          <p:nvPr/>
        </p:nvSpPr>
        <p:spPr>
          <a:xfrm>
            <a:off x="4914919" y="4082932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AD7300D-54C9-CBD1-CB33-AA465C4ADA23}"/>
              </a:ext>
            </a:extLst>
          </p:cNvPr>
          <p:cNvSpPr txBox="1"/>
          <p:nvPr/>
        </p:nvSpPr>
        <p:spPr>
          <a:xfrm>
            <a:off x="5346411" y="4082932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8E2DC76-2278-B217-465D-69F96634E374}"/>
              </a:ext>
            </a:extLst>
          </p:cNvPr>
          <p:cNvSpPr txBox="1"/>
          <p:nvPr/>
        </p:nvSpPr>
        <p:spPr>
          <a:xfrm rot="16200000">
            <a:off x="4202076" y="3381493"/>
            <a:ext cx="941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ICAM / 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0BA0B55-0CFE-8893-C7AB-27B875355E47}"/>
              </a:ext>
            </a:extLst>
          </p:cNvPr>
          <p:cNvSpPr txBox="1"/>
          <p:nvPr/>
        </p:nvSpPr>
        <p:spPr>
          <a:xfrm>
            <a:off x="1120137" y="5989502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9A4E054-3A16-ADF4-5C59-5F13820311C3}"/>
              </a:ext>
            </a:extLst>
          </p:cNvPr>
          <p:cNvSpPr txBox="1"/>
          <p:nvPr/>
        </p:nvSpPr>
        <p:spPr>
          <a:xfrm>
            <a:off x="1551629" y="5989502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083593-4B9A-2FD0-BA76-798AD8FB8237}"/>
              </a:ext>
            </a:extLst>
          </p:cNvPr>
          <p:cNvSpPr txBox="1"/>
          <p:nvPr/>
        </p:nvSpPr>
        <p:spPr>
          <a:xfrm rot="16200000">
            <a:off x="320732" y="5288063"/>
            <a:ext cx="1114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Vimentin / 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DA0F319-C764-41F3-12EC-54E245EFD7DF}"/>
              </a:ext>
            </a:extLst>
          </p:cNvPr>
          <p:cNvSpPr txBox="1"/>
          <p:nvPr/>
        </p:nvSpPr>
        <p:spPr>
          <a:xfrm>
            <a:off x="3082468" y="5989502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7C5EDFD-AE90-7C86-EC68-0516D3B80E4A}"/>
              </a:ext>
            </a:extLst>
          </p:cNvPr>
          <p:cNvSpPr txBox="1"/>
          <p:nvPr/>
        </p:nvSpPr>
        <p:spPr>
          <a:xfrm>
            <a:off x="3513960" y="5989502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412D905-C8B3-A4DA-8916-D9A01B3A3E1C}"/>
              </a:ext>
            </a:extLst>
          </p:cNvPr>
          <p:cNvSpPr txBox="1"/>
          <p:nvPr/>
        </p:nvSpPr>
        <p:spPr>
          <a:xfrm rot="16200000">
            <a:off x="2320733" y="5288063"/>
            <a:ext cx="10390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VCAM1 / 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graphicFrame>
        <p:nvGraphicFramePr>
          <p:cNvPr id="31" name="차트 30">
            <a:extLst>
              <a:ext uri="{FF2B5EF4-FFF2-40B4-BE49-F238E27FC236}">
                <a16:creationId xmlns:a16="http://schemas.microsoft.com/office/drawing/2014/main" id="{6842CF81-9177-4542-84FD-176080D071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1624688"/>
              </p:ext>
            </p:extLst>
          </p:nvPr>
        </p:nvGraphicFramePr>
        <p:xfrm>
          <a:off x="2754080" y="2570654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차트 31">
            <a:extLst>
              <a:ext uri="{FF2B5EF4-FFF2-40B4-BE49-F238E27FC236}">
                <a16:creationId xmlns:a16="http://schemas.microsoft.com/office/drawing/2014/main" id="{E86A625E-FE59-4AA7-9F5B-ECE9DC9BD1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4176907"/>
              </p:ext>
            </p:extLst>
          </p:nvPr>
        </p:nvGraphicFramePr>
        <p:xfrm>
          <a:off x="4717040" y="2570654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3" name="차트 32">
            <a:extLst>
              <a:ext uri="{FF2B5EF4-FFF2-40B4-BE49-F238E27FC236}">
                <a16:creationId xmlns:a16="http://schemas.microsoft.com/office/drawing/2014/main" id="{13554314-04EA-4144-AEA9-81D671F44DE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2188906"/>
              </p:ext>
            </p:extLst>
          </p:nvPr>
        </p:nvGraphicFramePr>
        <p:xfrm>
          <a:off x="970846" y="4477224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4" name="차트 63">
            <a:extLst>
              <a:ext uri="{FF2B5EF4-FFF2-40B4-BE49-F238E27FC236}">
                <a16:creationId xmlns:a16="http://schemas.microsoft.com/office/drawing/2014/main" id="{66B6EF1A-050C-4E6F-ADCF-363247FFE5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6848861"/>
              </p:ext>
            </p:extLst>
          </p:nvPr>
        </p:nvGraphicFramePr>
        <p:xfrm>
          <a:off x="2883960" y="4505322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986D65E6-6CBC-BE83-4E00-5DF0D3CBD4E8}"/>
              </a:ext>
            </a:extLst>
          </p:cNvPr>
          <p:cNvSpPr txBox="1"/>
          <p:nvPr/>
        </p:nvSpPr>
        <p:spPr>
          <a:xfrm>
            <a:off x="-12700" y="7105764"/>
            <a:ext cx="68707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7. A549-R cells exhibit increased invasive and</a:t>
            </a:r>
            <a:r>
              <a:rPr lang="ko-KR" altLang="en-US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ocal</a:t>
            </a:r>
            <a:r>
              <a:rPr lang="ko-KR" altLang="en-US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dhesion</a:t>
            </a:r>
            <a:r>
              <a:rPr lang="ko-KR" altLang="en-US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actors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4016824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>
            <a:extLst>
              <a:ext uri="{FF2B5EF4-FFF2-40B4-BE49-F238E27FC236}">
                <a16:creationId xmlns:a16="http://schemas.microsoft.com/office/drawing/2014/main" id="{48A6429D-7B49-EB59-BD22-8C4B7C5DE7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5921747"/>
              </p:ext>
            </p:extLst>
          </p:nvPr>
        </p:nvGraphicFramePr>
        <p:xfrm>
          <a:off x="1308921" y="2120067"/>
          <a:ext cx="412107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DE5A25D-87A5-C4F6-9051-89AEF995E827}"/>
              </a:ext>
            </a:extLst>
          </p:cNvPr>
          <p:cNvSpPr txBox="1"/>
          <p:nvPr/>
        </p:nvSpPr>
        <p:spPr>
          <a:xfrm rot="16200000">
            <a:off x="610332" y="2852590"/>
            <a:ext cx="1181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Relative mRNA level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EE33720-C4B9-4DDF-9227-C5B7AC746916}"/>
              </a:ext>
            </a:extLst>
          </p:cNvPr>
          <p:cNvSpPr txBox="1"/>
          <p:nvPr/>
        </p:nvSpPr>
        <p:spPr>
          <a:xfrm>
            <a:off x="3559720" y="5228104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7F2280D1-653A-D34C-6DDA-A7EB5A306396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99515" y="6264328"/>
            <a:ext cx="576000" cy="28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3ABAE590-9307-73E0-436A-D5330275F3DD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999515" y="5203592"/>
            <a:ext cx="576000" cy="28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5FC179B-4280-6614-8D8F-D2DB4A938FEF}"/>
              </a:ext>
            </a:extLst>
          </p:cNvPr>
          <p:cNvSpPr txBox="1"/>
          <p:nvPr/>
        </p:nvSpPr>
        <p:spPr>
          <a:xfrm>
            <a:off x="3559720" y="6285218"/>
            <a:ext cx="6992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75B843-4411-2110-4781-79D88D47525F}"/>
              </a:ext>
            </a:extLst>
          </p:cNvPr>
          <p:cNvSpPr txBox="1"/>
          <p:nvPr/>
        </p:nvSpPr>
        <p:spPr>
          <a:xfrm>
            <a:off x="3559720" y="4877025"/>
            <a:ext cx="7585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yclin E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EF33A5D-6267-69E9-B91C-362A5D6AC80B}"/>
              </a:ext>
            </a:extLst>
          </p:cNvPr>
          <p:cNvSpPr txBox="1"/>
          <p:nvPr/>
        </p:nvSpPr>
        <p:spPr>
          <a:xfrm>
            <a:off x="3559720" y="5567896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94B5E7FD-3058-A76E-D506-7506BA1E9CF0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999515" y="5907688"/>
            <a:ext cx="576000" cy="28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7A2A845D-31E8-FDC1-C174-A847D6182EA8}"/>
              </a:ext>
            </a:extLst>
          </p:cNvPr>
          <p:cNvSpPr txBox="1"/>
          <p:nvPr/>
        </p:nvSpPr>
        <p:spPr>
          <a:xfrm>
            <a:off x="3559720" y="5928577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DK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50EAD0E-EDD2-1A34-2B14-3D293FEA8FFA}"/>
              </a:ext>
            </a:extLst>
          </p:cNvPr>
          <p:cNvSpPr txBox="1"/>
          <p:nvPr/>
        </p:nvSpPr>
        <p:spPr>
          <a:xfrm rot="16200000">
            <a:off x="2795452" y="4390435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CCCDC97-6C85-2FE7-1437-B3513BE2F365}"/>
              </a:ext>
            </a:extLst>
          </p:cNvPr>
          <p:cNvSpPr txBox="1"/>
          <p:nvPr/>
        </p:nvSpPr>
        <p:spPr>
          <a:xfrm rot="16200000">
            <a:off x="3089242" y="4404862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E7AA90A-DE4F-8028-EE1B-D6A085B664FD}"/>
              </a:ext>
            </a:extLst>
          </p:cNvPr>
          <p:cNvSpPr txBox="1"/>
          <p:nvPr/>
        </p:nvSpPr>
        <p:spPr>
          <a:xfrm>
            <a:off x="2518559" y="4556627"/>
            <a:ext cx="43205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그룹 19">
            <a:extLst>
              <a:ext uri="{FF2B5EF4-FFF2-40B4-BE49-F238E27FC236}">
                <a16:creationId xmlns:a16="http://schemas.microsoft.com/office/drawing/2014/main" id="{1CAEB5E5-6771-028C-AE86-E3349762EBD3}"/>
              </a:ext>
            </a:extLst>
          </p:cNvPr>
          <p:cNvGrpSpPr/>
          <p:nvPr/>
        </p:nvGrpSpPr>
        <p:grpSpPr>
          <a:xfrm>
            <a:off x="2572771" y="4748414"/>
            <a:ext cx="337988" cy="215444"/>
            <a:chOff x="1121394" y="7538164"/>
            <a:chExt cx="337988" cy="215444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09C7A1E-BA06-883D-034B-7EC4219569BE}"/>
                </a:ext>
              </a:extLst>
            </p:cNvPr>
            <p:cNvSpPr txBox="1"/>
            <p:nvPr/>
          </p:nvSpPr>
          <p:spPr>
            <a:xfrm>
              <a:off x="1121394" y="7538164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DF1B27BE-A719-F956-37BA-1EDF75ABBA74}"/>
                </a:ext>
              </a:extLst>
            </p:cNvPr>
            <p:cNvCxnSpPr/>
            <p:nvPr/>
          </p:nvCxnSpPr>
          <p:spPr>
            <a:xfrm>
              <a:off x="1351382" y="7646721"/>
              <a:ext cx="10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24" name="그림 23">
            <a:extLst>
              <a:ext uri="{FF2B5EF4-FFF2-40B4-BE49-F238E27FC236}">
                <a16:creationId xmlns:a16="http://schemas.microsoft.com/office/drawing/2014/main" id="{6C5E624F-FCE1-FF1D-C486-1F0FF6B616F8}"/>
              </a:ext>
            </a:extLst>
          </p:cNvPr>
          <p:cNvPicPr preferRelativeResize="0">
            <a:picLocks/>
          </p:cNvPicPr>
          <p:nvPr/>
        </p:nvPicPr>
        <p:blipFill>
          <a:blip r:embed="rId6">
            <a:lum bright="-20000"/>
          </a:blip>
          <a:stretch>
            <a:fillRect/>
          </a:stretch>
        </p:blipFill>
        <p:spPr>
          <a:xfrm>
            <a:off x="2999514" y="4856136"/>
            <a:ext cx="576000" cy="288000"/>
          </a:xfrm>
          <a:prstGeom prst="rect">
            <a:avLst/>
          </a:prstGeom>
          <a:ln w="12700">
            <a:solidFill>
              <a:schemeClr val="dk1"/>
            </a:solidFill>
          </a:ln>
        </p:spPr>
      </p:pic>
      <p:grpSp>
        <p:nvGrpSpPr>
          <p:cNvPr id="25" name="그룹 24">
            <a:extLst>
              <a:ext uri="{FF2B5EF4-FFF2-40B4-BE49-F238E27FC236}">
                <a16:creationId xmlns:a16="http://schemas.microsoft.com/office/drawing/2014/main" id="{C05A3C25-2734-81C0-AA38-B1338519D689}"/>
              </a:ext>
            </a:extLst>
          </p:cNvPr>
          <p:cNvGrpSpPr/>
          <p:nvPr/>
        </p:nvGrpSpPr>
        <p:grpSpPr>
          <a:xfrm>
            <a:off x="2572771" y="5095870"/>
            <a:ext cx="337988" cy="215444"/>
            <a:chOff x="1121394" y="7538164"/>
            <a:chExt cx="337988" cy="215444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B0EEFFB-D8AA-542E-E7E0-016F3B6E4044}"/>
                </a:ext>
              </a:extLst>
            </p:cNvPr>
            <p:cNvSpPr txBox="1"/>
            <p:nvPr/>
          </p:nvSpPr>
          <p:spPr>
            <a:xfrm>
              <a:off x="1121394" y="7538164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E5A23F40-4560-4DA9-3F7E-427D9E69C9E9}"/>
                </a:ext>
              </a:extLst>
            </p:cNvPr>
            <p:cNvCxnSpPr/>
            <p:nvPr/>
          </p:nvCxnSpPr>
          <p:spPr>
            <a:xfrm>
              <a:off x="1351382" y="7646721"/>
              <a:ext cx="10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8" name="그룹 27">
            <a:extLst>
              <a:ext uri="{FF2B5EF4-FFF2-40B4-BE49-F238E27FC236}">
                <a16:creationId xmlns:a16="http://schemas.microsoft.com/office/drawing/2014/main" id="{A65493D2-3E09-14D1-BC26-4BA1C1DAA7BF}"/>
              </a:ext>
            </a:extLst>
          </p:cNvPr>
          <p:cNvGrpSpPr/>
          <p:nvPr/>
        </p:nvGrpSpPr>
        <p:grpSpPr>
          <a:xfrm>
            <a:off x="2572771" y="5461513"/>
            <a:ext cx="337988" cy="215444"/>
            <a:chOff x="1121394" y="7538164"/>
            <a:chExt cx="337988" cy="215444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718C977-2003-6EEA-43D9-E4AA729393D0}"/>
                </a:ext>
              </a:extLst>
            </p:cNvPr>
            <p:cNvSpPr txBox="1"/>
            <p:nvPr/>
          </p:nvSpPr>
          <p:spPr>
            <a:xfrm>
              <a:off x="1121394" y="7538164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직선 연결선 29">
              <a:extLst>
                <a:ext uri="{FF2B5EF4-FFF2-40B4-BE49-F238E27FC236}">
                  <a16:creationId xmlns:a16="http://schemas.microsoft.com/office/drawing/2014/main" id="{DA67F454-EFFE-4C09-9D17-2F6B1E7E9A48}"/>
                </a:ext>
              </a:extLst>
            </p:cNvPr>
            <p:cNvCxnSpPr/>
            <p:nvPr/>
          </p:nvCxnSpPr>
          <p:spPr>
            <a:xfrm>
              <a:off x="1351382" y="7646721"/>
              <a:ext cx="10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1" name="그룹 30">
            <a:extLst>
              <a:ext uri="{FF2B5EF4-FFF2-40B4-BE49-F238E27FC236}">
                <a16:creationId xmlns:a16="http://schemas.microsoft.com/office/drawing/2014/main" id="{C6632BBF-2925-FF5E-8901-8C99A92CC536}"/>
              </a:ext>
            </a:extLst>
          </p:cNvPr>
          <p:cNvGrpSpPr/>
          <p:nvPr/>
        </p:nvGrpSpPr>
        <p:grpSpPr>
          <a:xfrm>
            <a:off x="2572771" y="5814952"/>
            <a:ext cx="337988" cy="215444"/>
            <a:chOff x="1121394" y="7538164"/>
            <a:chExt cx="337988" cy="215444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BCE15F3-C110-A4CD-C671-FE3C2D6C15D1}"/>
                </a:ext>
              </a:extLst>
            </p:cNvPr>
            <p:cNvSpPr txBox="1"/>
            <p:nvPr/>
          </p:nvSpPr>
          <p:spPr>
            <a:xfrm>
              <a:off x="1121394" y="7538164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DF6A4983-0713-753C-6AE1-A0A3B9D3FA86}"/>
                </a:ext>
              </a:extLst>
            </p:cNvPr>
            <p:cNvCxnSpPr/>
            <p:nvPr/>
          </p:nvCxnSpPr>
          <p:spPr>
            <a:xfrm>
              <a:off x="1351382" y="7646721"/>
              <a:ext cx="10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35" name="그림 34">
            <a:extLst>
              <a:ext uri="{FF2B5EF4-FFF2-40B4-BE49-F238E27FC236}">
                <a16:creationId xmlns:a16="http://schemas.microsoft.com/office/drawing/2014/main" id="{0C2942C5-E2E3-2D93-25ED-96CA071F5105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999514" y="5558179"/>
            <a:ext cx="576000" cy="288000"/>
          </a:xfrm>
          <a:prstGeom prst="rect">
            <a:avLst/>
          </a:prstGeom>
          <a:ln w="12700">
            <a:solidFill>
              <a:schemeClr val="dk1"/>
            </a:solidFill>
          </a:ln>
        </p:spPr>
      </p:pic>
      <p:grpSp>
        <p:nvGrpSpPr>
          <p:cNvPr id="36" name="그룹 35">
            <a:extLst>
              <a:ext uri="{FF2B5EF4-FFF2-40B4-BE49-F238E27FC236}">
                <a16:creationId xmlns:a16="http://schemas.microsoft.com/office/drawing/2014/main" id="{DA12A641-624D-28E4-8338-3B3158847CB3}"/>
              </a:ext>
            </a:extLst>
          </p:cNvPr>
          <p:cNvGrpSpPr/>
          <p:nvPr/>
        </p:nvGrpSpPr>
        <p:grpSpPr>
          <a:xfrm>
            <a:off x="2572771" y="6183630"/>
            <a:ext cx="337988" cy="215444"/>
            <a:chOff x="1121394" y="7538164"/>
            <a:chExt cx="337988" cy="215444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61C2120-1084-EEDC-CE99-53C086BD31B5}"/>
                </a:ext>
              </a:extLst>
            </p:cNvPr>
            <p:cNvSpPr txBox="1"/>
            <p:nvPr/>
          </p:nvSpPr>
          <p:spPr>
            <a:xfrm>
              <a:off x="1121394" y="7538164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직선 연결선 37">
              <a:extLst>
                <a:ext uri="{FF2B5EF4-FFF2-40B4-BE49-F238E27FC236}">
                  <a16:creationId xmlns:a16="http://schemas.microsoft.com/office/drawing/2014/main" id="{BC16BBEB-AEC9-D70D-F0F6-F910A590A8ED}"/>
                </a:ext>
              </a:extLst>
            </p:cNvPr>
            <p:cNvCxnSpPr/>
            <p:nvPr/>
          </p:nvCxnSpPr>
          <p:spPr>
            <a:xfrm>
              <a:off x="1351382" y="7646721"/>
              <a:ext cx="10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17D673F5-8989-7E5A-08F6-59867C9103BC}"/>
              </a:ext>
            </a:extLst>
          </p:cNvPr>
          <p:cNvSpPr txBox="1"/>
          <p:nvPr/>
        </p:nvSpPr>
        <p:spPr>
          <a:xfrm>
            <a:off x="-12700" y="7105764"/>
            <a:ext cx="68707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8. A549-R cells show little effect on expression of cell cycle regulators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9904902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9AA4A7B3-A72A-B920-D12A-2B98DEFECB09}"/>
              </a:ext>
            </a:extLst>
          </p:cNvPr>
          <p:cNvSpPr txBox="1"/>
          <p:nvPr/>
        </p:nvSpPr>
        <p:spPr>
          <a:xfrm rot="16200000">
            <a:off x="435826" y="1597314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A520DD4-5C6C-B02F-B4A0-6280D877B6BE}"/>
              </a:ext>
            </a:extLst>
          </p:cNvPr>
          <p:cNvSpPr txBox="1"/>
          <p:nvPr/>
        </p:nvSpPr>
        <p:spPr>
          <a:xfrm rot="16200000">
            <a:off x="971692" y="1597314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F2C0AEC-EF5B-2B7C-8B1A-E4A55C48A8FD}"/>
              </a:ext>
            </a:extLst>
          </p:cNvPr>
          <p:cNvSpPr txBox="1"/>
          <p:nvPr/>
        </p:nvSpPr>
        <p:spPr>
          <a:xfrm rot="16200000">
            <a:off x="711170" y="1586093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67063AC-EBE3-0C3E-2C9B-2BFB4FC63C22}"/>
              </a:ext>
            </a:extLst>
          </p:cNvPr>
          <p:cNvSpPr txBox="1"/>
          <p:nvPr/>
        </p:nvSpPr>
        <p:spPr>
          <a:xfrm rot="16200000">
            <a:off x="1254656" y="1586093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D82CA33B-CD31-1119-034C-C3DED409B2E5}"/>
              </a:ext>
            </a:extLst>
          </p:cNvPr>
          <p:cNvCxnSpPr>
            <a:cxnSpLocks/>
          </p:cNvCxnSpPr>
          <p:nvPr/>
        </p:nvCxnSpPr>
        <p:spPr>
          <a:xfrm>
            <a:off x="631210" y="1963281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EB8B526B-2AE9-8B85-B67B-13A1CC19BF47}"/>
              </a:ext>
            </a:extLst>
          </p:cNvPr>
          <p:cNvCxnSpPr>
            <a:cxnSpLocks/>
          </p:cNvCxnSpPr>
          <p:nvPr/>
        </p:nvCxnSpPr>
        <p:spPr>
          <a:xfrm>
            <a:off x="1199843" y="1963281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49928E1B-2298-D2CB-8EFA-CE0EDDA8A2DE}"/>
              </a:ext>
            </a:extLst>
          </p:cNvPr>
          <p:cNvSpPr txBox="1"/>
          <p:nvPr/>
        </p:nvSpPr>
        <p:spPr>
          <a:xfrm>
            <a:off x="735598" y="19632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E3B7FDA-D34E-F436-2ABC-A39A65729F6D}"/>
              </a:ext>
            </a:extLst>
          </p:cNvPr>
          <p:cNvSpPr txBox="1"/>
          <p:nvPr/>
        </p:nvSpPr>
        <p:spPr>
          <a:xfrm>
            <a:off x="1207752" y="1985722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BB6838D-2848-77A1-9A59-DEF315025B7E}"/>
              </a:ext>
            </a:extLst>
          </p:cNvPr>
          <p:cNvSpPr txBox="1"/>
          <p:nvPr/>
        </p:nvSpPr>
        <p:spPr>
          <a:xfrm rot="16200000">
            <a:off x="-165314" y="959826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3K27me3 / H3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76E79FDD-DFA1-C594-EB92-4200745101E2}"/>
              </a:ext>
            </a:extLst>
          </p:cNvPr>
          <p:cNvSpPr txBox="1"/>
          <p:nvPr/>
        </p:nvSpPr>
        <p:spPr>
          <a:xfrm rot="16200000">
            <a:off x="2044257" y="1597314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04A316C-3E8F-54E5-D626-02E41E1B7DAB}"/>
              </a:ext>
            </a:extLst>
          </p:cNvPr>
          <p:cNvSpPr txBox="1"/>
          <p:nvPr/>
        </p:nvSpPr>
        <p:spPr>
          <a:xfrm rot="16200000">
            <a:off x="2580123" y="1597314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A4217269-11C4-20EF-DD6D-E2A2E4F821A4}"/>
              </a:ext>
            </a:extLst>
          </p:cNvPr>
          <p:cNvSpPr txBox="1"/>
          <p:nvPr/>
        </p:nvSpPr>
        <p:spPr>
          <a:xfrm rot="16200000">
            <a:off x="2319601" y="1586093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FA7926F2-0F55-760B-DFC0-765167D4316E}"/>
              </a:ext>
            </a:extLst>
          </p:cNvPr>
          <p:cNvSpPr txBox="1"/>
          <p:nvPr/>
        </p:nvSpPr>
        <p:spPr>
          <a:xfrm rot="16200000">
            <a:off x="2863087" y="1586093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직선 연결선 107">
            <a:extLst>
              <a:ext uri="{FF2B5EF4-FFF2-40B4-BE49-F238E27FC236}">
                <a16:creationId xmlns:a16="http://schemas.microsoft.com/office/drawing/2014/main" id="{B6D82C90-C955-A6DA-56FC-8F1D9FB3EA98}"/>
              </a:ext>
            </a:extLst>
          </p:cNvPr>
          <p:cNvCxnSpPr>
            <a:cxnSpLocks/>
          </p:cNvCxnSpPr>
          <p:nvPr/>
        </p:nvCxnSpPr>
        <p:spPr>
          <a:xfrm>
            <a:off x="2239641" y="1963281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id="{9364153E-021E-0A72-AD0E-6F0E866D1B68}"/>
              </a:ext>
            </a:extLst>
          </p:cNvPr>
          <p:cNvCxnSpPr>
            <a:cxnSpLocks/>
          </p:cNvCxnSpPr>
          <p:nvPr/>
        </p:nvCxnSpPr>
        <p:spPr>
          <a:xfrm>
            <a:off x="2808274" y="1963281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165CFD23-DAE5-595E-0ECB-6D21D010F542}"/>
              </a:ext>
            </a:extLst>
          </p:cNvPr>
          <p:cNvSpPr txBox="1"/>
          <p:nvPr/>
        </p:nvSpPr>
        <p:spPr>
          <a:xfrm>
            <a:off x="2344029" y="19632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69FD738-692A-D665-00AC-EB61E5448CED}"/>
              </a:ext>
            </a:extLst>
          </p:cNvPr>
          <p:cNvSpPr txBox="1"/>
          <p:nvPr/>
        </p:nvSpPr>
        <p:spPr>
          <a:xfrm>
            <a:off x="2816183" y="1985722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B858755E-4C33-4BEB-B8D9-FEBA52750DD2}"/>
              </a:ext>
            </a:extLst>
          </p:cNvPr>
          <p:cNvSpPr txBox="1"/>
          <p:nvPr/>
        </p:nvSpPr>
        <p:spPr>
          <a:xfrm rot="16200000">
            <a:off x="1443117" y="959826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3K27me3 / H3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D60435F1-2CB7-6AD0-EB99-CD18163F9A77}"/>
              </a:ext>
            </a:extLst>
          </p:cNvPr>
          <p:cNvSpPr txBox="1"/>
          <p:nvPr/>
        </p:nvSpPr>
        <p:spPr>
          <a:xfrm rot="16200000">
            <a:off x="3621378" y="1600700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38E476C-534A-EA4E-1C59-040220974D4D}"/>
              </a:ext>
            </a:extLst>
          </p:cNvPr>
          <p:cNvSpPr txBox="1"/>
          <p:nvPr/>
        </p:nvSpPr>
        <p:spPr>
          <a:xfrm rot="16200000">
            <a:off x="4157244" y="1600700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2995A352-D62F-87DE-48EE-76C11F126551}"/>
              </a:ext>
            </a:extLst>
          </p:cNvPr>
          <p:cNvSpPr txBox="1"/>
          <p:nvPr/>
        </p:nvSpPr>
        <p:spPr>
          <a:xfrm rot="16200000">
            <a:off x="3896722" y="1589479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D2D6F8DC-FD99-77F6-8B87-79EAB808C37E}"/>
              </a:ext>
            </a:extLst>
          </p:cNvPr>
          <p:cNvSpPr txBox="1"/>
          <p:nvPr/>
        </p:nvSpPr>
        <p:spPr>
          <a:xfrm rot="16200000">
            <a:off x="4440208" y="1589479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id="{1DA152C1-CEAB-28BC-0D6C-5FD293BE61CC}"/>
              </a:ext>
            </a:extLst>
          </p:cNvPr>
          <p:cNvCxnSpPr>
            <a:cxnSpLocks/>
          </p:cNvCxnSpPr>
          <p:nvPr/>
        </p:nvCxnSpPr>
        <p:spPr>
          <a:xfrm>
            <a:off x="3816762" y="1966667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직선 연결선 119">
            <a:extLst>
              <a:ext uri="{FF2B5EF4-FFF2-40B4-BE49-F238E27FC236}">
                <a16:creationId xmlns:a16="http://schemas.microsoft.com/office/drawing/2014/main" id="{8184A786-D694-A2F3-6B21-8E738E281ED4}"/>
              </a:ext>
            </a:extLst>
          </p:cNvPr>
          <p:cNvCxnSpPr>
            <a:cxnSpLocks/>
          </p:cNvCxnSpPr>
          <p:nvPr/>
        </p:nvCxnSpPr>
        <p:spPr>
          <a:xfrm>
            <a:off x="4385395" y="1966667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474CDA99-7AEB-45CB-96EB-02CAEFD92465}"/>
              </a:ext>
            </a:extLst>
          </p:cNvPr>
          <p:cNvSpPr txBox="1"/>
          <p:nvPr/>
        </p:nvSpPr>
        <p:spPr>
          <a:xfrm>
            <a:off x="3921150" y="1966667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0BA513A6-2BDF-8E4C-BB3D-E27969C4684A}"/>
              </a:ext>
            </a:extLst>
          </p:cNvPr>
          <p:cNvSpPr txBox="1"/>
          <p:nvPr/>
        </p:nvSpPr>
        <p:spPr>
          <a:xfrm>
            <a:off x="4393304" y="1989108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B20DE5C-D4F1-0880-114F-561BD13656F7}"/>
              </a:ext>
            </a:extLst>
          </p:cNvPr>
          <p:cNvSpPr txBox="1"/>
          <p:nvPr/>
        </p:nvSpPr>
        <p:spPr>
          <a:xfrm rot="16200000">
            <a:off x="3020238" y="963212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3K36me2 / H3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81B5192D-4BA9-4386-DDC5-91B58D5BD061}"/>
              </a:ext>
            </a:extLst>
          </p:cNvPr>
          <p:cNvSpPr txBox="1"/>
          <p:nvPr/>
        </p:nvSpPr>
        <p:spPr>
          <a:xfrm rot="16200000">
            <a:off x="5262728" y="1597314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4E3B52E4-8C53-80EB-DEDA-6D365BA0BFFF}"/>
              </a:ext>
            </a:extLst>
          </p:cNvPr>
          <p:cNvSpPr txBox="1"/>
          <p:nvPr/>
        </p:nvSpPr>
        <p:spPr>
          <a:xfrm rot="16200000">
            <a:off x="5798594" y="1597314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1DB80990-29AF-B5DA-A1AA-10FA3CDF61A5}"/>
              </a:ext>
            </a:extLst>
          </p:cNvPr>
          <p:cNvSpPr txBox="1"/>
          <p:nvPr/>
        </p:nvSpPr>
        <p:spPr>
          <a:xfrm rot="16200000">
            <a:off x="5538072" y="1586093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27DB6C8E-518C-63ED-4A36-14C61B0B46A9}"/>
              </a:ext>
            </a:extLst>
          </p:cNvPr>
          <p:cNvSpPr txBox="1"/>
          <p:nvPr/>
        </p:nvSpPr>
        <p:spPr>
          <a:xfrm rot="16200000">
            <a:off x="6081558" y="1586093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직선 연결선 129">
            <a:extLst>
              <a:ext uri="{FF2B5EF4-FFF2-40B4-BE49-F238E27FC236}">
                <a16:creationId xmlns:a16="http://schemas.microsoft.com/office/drawing/2014/main" id="{F2DED947-4278-E2F6-3706-B7A3FCDD6653}"/>
              </a:ext>
            </a:extLst>
          </p:cNvPr>
          <p:cNvCxnSpPr>
            <a:cxnSpLocks/>
          </p:cNvCxnSpPr>
          <p:nvPr/>
        </p:nvCxnSpPr>
        <p:spPr>
          <a:xfrm>
            <a:off x="5458112" y="1963281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직선 연결선 130">
            <a:extLst>
              <a:ext uri="{FF2B5EF4-FFF2-40B4-BE49-F238E27FC236}">
                <a16:creationId xmlns:a16="http://schemas.microsoft.com/office/drawing/2014/main" id="{6E3B8DB7-875E-3846-2432-747F10BE77F1}"/>
              </a:ext>
            </a:extLst>
          </p:cNvPr>
          <p:cNvCxnSpPr>
            <a:cxnSpLocks/>
          </p:cNvCxnSpPr>
          <p:nvPr/>
        </p:nvCxnSpPr>
        <p:spPr>
          <a:xfrm>
            <a:off x="6026745" y="1963281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id="{799B879D-D2F0-76C7-17C7-C43DB8D74384}"/>
              </a:ext>
            </a:extLst>
          </p:cNvPr>
          <p:cNvSpPr txBox="1"/>
          <p:nvPr/>
        </p:nvSpPr>
        <p:spPr>
          <a:xfrm>
            <a:off x="5562500" y="19632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24148AB3-EC98-8D8E-E4CF-E2893A810778}"/>
              </a:ext>
            </a:extLst>
          </p:cNvPr>
          <p:cNvSpPr txBox="1"/>
          <p:nvPr/>
        </p:nvSpPr>
        <p:spPr>
          <a:xfrm>
            <a:off x="6034654" y="1985722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8FB12EFB-EBC8-BEFA-B5E2-73224D4BEB3D}"/>
              </a:ext>
            </a:extLst>
          </p:cNvPr>
          <p:cNvSpPr txBox="1"/>
          <p:nvPr/>
        </p:nvSpPr>
        <p:spPr>
          <a:xfrm rot="16200000">
            <a:off x="4661588" y="959826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3K36me3 / H3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93D4DDBB-0018-370B-38BF-7D57B2900FA6}"/>
              </a:ext>
            </a:extLst>
          </p:cNvPr>
          <p:cNvSpPr txBox="1"/>
          <p:nvPr/>
        </p:nvSpPr>
        <p:spPr>
          <a:xfrm rot="16200000">
            <a:off x="435826" y="365123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187A164F-4433-8D06-E227-6C267CD9307A}"/>
              </a:ext>
            </a:extLst>
          </p:cNvPr>
          <p:cNvSpPr txBox="1"/>
          <p:nvPr/>
        </p:nvSpPr>
        <p:spPr>
          <a:xfrm rot="16200000">
            <a:off x="971692" y="365123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02E25F67-FE54-D322-8ECE-B12B286AD4D9}"/>
              </a:ext>
            </a:extLst>
          </p:cNvPr>
          <p:cNvSpPr txBox="1"/>
          <p:nvPr/>
        </p:nvSpPr>
        <p:spPr>
          <a:xfrm rot="16200000">
            <a:off x="711170" y="364001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4B1977B6-9F89-5525-8A49-887C74F044A8}"/>
              </a:ext>
            </a:extLst>
          </p:cNvPr>
          <p:cNvSpPr txBox="1"/>
          <p:nvPr/>
        </p:nvSpPr>
        <p:spPr>
          <a:xfrm rot="16200000">
            <a:off x="1254656" y="364001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직선 연결선 140">
            <a:extLst>
              <a:ext uri="{FF2B5EF4-FFF2-40B4-BE49-F238E27FC236}">
                <a16:creationId xmlns:a16="http://schemas.microsoft.com/office/drawing/2014/main" id="{63100FAB-82D1-9858-E4EC-BFD6F2CC0571}"/>
              </a:ext>
            </a:extLst>
          </p:cNvPr>
          <p:cNvCxnSpPr>
            <a:cxnSpLocks/>
          </p:cNvCxnSpPr>
          <p:nvPr/>
        </p:nvCxnSpPr>
        <p:spPr>
          <a:xfrm>
            <a:off x="631210" y="401719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직선 연결선 141">
            <a:extLst>
              <a:ext uri="{FF2B5EF4-FFF2-40B4-BE49-F238E27FC236}">
                <a16:creationId xmlns:a16="http://schemas.microsoft.com/office/drawing/2014/main" id="{B23A2383-1626-A1E4-3EF0-F90AD6803A8A}"/>
              </a:ext>
            </a:extLst>
          </p:cNvPr>
          <p:cNvCxnSpPr>
            <a:cxnSpLocks/>
          </p:cNvCxnSpPr>
          <p:nvPr/>
        </p:nvCxnSpPr>
        <p:spPr>
          <a:xfrm>
            <a:off x="1199843" y="401719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A76A2DB9-0C1C-9CCD-0141-294F486FA8A2}"/>
              </a:ext>
            </a:extLst>
          </p:cNvPr>
          <p:cNvSpPr txBox="1"/>
          <p:nvPr/>
        </p:nvSpPr>
        <p:spPr>
          <a:xfrm>
            <a:off x="735598" y="4017198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6F181294-DCF6-E7C3-1BF6-7AE349EFA35C}"/>
              </a:ext>
            </a:extLst>
          </p:cNvPr>
          <p:cNvSpPr txBox="1"/>
          <p:nvPr/>
        </p:nvSpPr>
        <p:spPr>
          <a:xfrm>
            <a:off x="1207752" y="4039639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A5F7DD2A-FA71-98E1-E4B2-C2197AA260A2}"/>
              </a:ext>
            </a:extLst>
          </p:cNvPr>
          <p:cNvSpPr txBox="1"/>
          <p:nvPr/>
        </p:nvSpPr>
        <p:spPr>
          <a:xfrm rot="16200000">
            <a:off x="-136460" y="3013743"/>
            <a:ext cx="8723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3K9me2 / H3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5766FA9C-0CDC-852F-5BB6-09B74B1E034A}"/>
              </a:ext>
            </a:extLst>
          </p:cNvPr>
          <p:cNvSpPr txBox="1"/>
          <p:nvPr/>
        </p:nvSpPr>
        <p:spPr>
          <a:xfrm rot="16200000">
            <a:off x="2044257" y="365123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D477311B-BF2F-8FE5-2010-97A6C417C923}"/>
              </a:ext>
            </a:extLst>
          </p:cNvPr>
          <p:cNvSpPr txBox="1"/>
          <p:nvPr/>
        </p:nvSpPr>
        <p:spPr>
          <a:xfrm rot="16200000">
            <a:off x="2580123" y="365123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A77654B9-82E2-135F-DFB7-6C10E0007996}"/>
              </a:ext>
            </a:extLst>
          </p:cNvPr>
          <p:cNvSpPr txBox="1"/>
          <p:nvPr/>
        </p:nvSpPr>
        <p:spPr>
          <a:xfrm rot="16200000">
            <a:off x="2319601" y="364001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E7C5CBE2-6757-B3B4-1046-776F44545A5D}"/>
              </a:ext>
            </a:extLst>
          </p:cNvPr>
          <p:cNvSpPr txBox="1"/>
          <p:nvPr/>
        </p:nvSpPr>
        <p:spPr>
          <a:xfrm rot="16200000">
            <a:off x="2863087" y="364001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직선 연결선 151">
            <a:extLst>
              <a:ext uri="{FF2B5EF4-FFF2-40B4-BE49-F238E27FC236}">
                <a16:creationId xmlns:a16="http://schemas.microsoft.com/office/drawing/2014/main" id="{FA8918BD-8C0E-BFF8-ADF4-815DB5987980}"/>
              </a:ext>
            </a:extLst>
          </p:cNvPr>
          <p:cNvCxnSpPr>
            <a:cxnSpLocks/>
          </p:cNvCxnSpPr>
          <p:nvPr/>
        </p:nvCxnSpPr>
        <p:spPr>
          <a:xfrm>
            <a:off x="2239641" y="401719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직선 연결선 152">
            <a:extLst>
              <a:ext uri="{FF2B5EF4-FFF2-40B4-BE49-F238E27FC236}">
                <a16:creationId xmlns:a16="http://schemas.microsoft.com/office/drawing/2014/main" id="{E4860941-0FA4-5A90-7873-7D33E5D133EE}"/>
              </a:ext>
            </a:extLst>
          </p:cNvPr>
          <p:cNvCxnSpPr>
            <a:cxnSpLocks/>
          </p:cNvCxnSpPr>
          <p:nvPr/>
        </p:nvCxnSpPr>
        <p:spPr>
          <a:xfrm>
            <a:off x="2808274" y="401719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9EDF60C1-D3F5-7067-51E1-839AAC88985F}"/>
              </a:ext>
            </a:extLst>
          </p:cNvPr>
          <p:cNvSpPr txBox="1"/>
          <p:nvPr/>
        </p:nvSpPr>
        <p:spPr>
          <a:xfrm>
            <a:off x="2344029" y="4017198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DDC33A7D-6C13-A133-B2CD-37775B1F9306}"/>
              </a:ext>
            </a:extLst>
          </p:cNvPr>
          <p:cNvSpPr txBox="1"/>
          <p:nvPr/>
        </p:nvSpPr>
        <p:spPr>
          <a:xfrm>
            <a:off x="2816183" y="4039639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3A81454D-A12A-9F01-DA33-D29AAA49863A}"/>
              </a:ext>
            </a:extLst>
          </p:cNvPr>
          <p:cNvSpPr txBox="1"/>
          <p:nvPr/>
        </p:nvSpPr>
        <p:spPr>
          <a:xfrm rot="16200000">
            <a:off x="1471971" y="3013743"/>
            <a:ext cx="8723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3K9me3 / H3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ADF7BEB4-2087-6E08-B61E-817FE53BF4CA}"/>
              </a:ext>
            </a:extLst>
          </p:cNvPr>
          <p:cNvSpPr txBox="1"/>
          <p:nvPr/>
        </p:nvSpPr>
        <p:spPr>
          <a:xfrm rot="16200000">
            <a:off x="3621378" y="3654617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BE198E63-1415-D13C-D15B-6AF7A0AE6D88}"/>
              </a:ext>
            </a:extLst>
          </p:cNvPr>
          <p:cNvSpPr txBox="1"/>
          <p:nvPr/>
        </p:nvSpPr>
        <p:spPr>
          <a:xfrm rot="16200000">
            <a:off x="4157244" y="3654617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7678BB1D-9453-A4A3-9897-FDE99B997EE4}"/>
              </a:ext>
            </a:extLst>
          </p:cNvPr>
          <p:cNvSpPr txBox="1"/>
          <p:nvPr/>
        </p:nvSpPr>
        <p:spPr>
          <a:xfrm rot="16200000">
            <a:off x="3896722" y="3643396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26D3E760-FEFE-78D0-79C8-F8F86B6072AA}"/>
              </a:ext>
            </a:extLst>
          </p:cNvPr>
          <p:cNvSpPr txBox="1"/>
          <p:nvPr/>
        </p:nvSpPr>
        <p:spPr>
          <a:xfrm rot="16200000">
            <a:off x="4440208" y="3643396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직선 연결선 162">
            <a:extLst>
              <a:ext uri="{FF2B5EF4-FFF2-40B4-BE49-F238E27FC236}">
                <a16:creationId xmlns:a16="http://schemas.microsoft.com/office/drawing/2014/main" id="{C6F448F6-B255-21A8-4196-188D5ECBBCDB}"/>
              </a:ext>
            </a:extLst>
          </p:cNvPr>
          <p:cNvCxnSpPr>
            <a:cxnSpLocks/>
          </p:cNvCxnSpPr>
          <p:nvPr/>
        </p:nvCxnSpPr>
        <p:spPr>
          <a:xfrm>
            <a:off x="3816762" y="4020584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id="{DEA90E27-BC3C-CF39-0548-8403B9D5F677}"/>
              </a:ext>
            </a:extLst>
          </p:cNvPr>
          <p:cNvCxnSpPr>
            <a:cxnSpLocks/>
          </p:cNvCxnSpPr>
          <p:nvPr/>
        </p:nvCxnSpPr>
        <p:spPr>
          <a:xfrm>
            <a:off x="4385395" y="4020584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id="{150CC6B8-2CF7-F4A1-2F76-C3BA141BFB47}"/>
              </a:ext>
            </a:extLst>
          </p:cNvPr>
          <p:cNvSpPr txBox="1"/>
          <p:nvPr/>
        </p:nvSpPr>
        <p:spPr>
          <a:xfrm>
            <a:off x="3921150" y="402058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727C7525-0DDB-5B82-6487-77A655E70EC4}"/>
              </a:ext>
            </a:extLst>
          </p:cNvPr>
          <p:cNvSpPr txBox="1"/>
          <p:nvPr/>
        </p:nvSpPr>
        <p:spPr>
          <a:xfrm>
            <a:off x="4393304" y="4043025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D72B6E66-E857-2E99-49C7-BEEF9C2AA7E6}"/>
              </a:ext>
            </a:extLst>
          </p:cNvPr>
          <p:cNvSpPr txBox="1"/>
          <p:nvPr/>
        </p:nvSpPr>
        <p:spPr>
          <a:xfrm rot="16200000">
            <a:off x="3020238" y="3017129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3K27me2 / H3</a:t>
            </a:r>
          </a:p>
        </p:txBody>
      </p:sp>
      <p:graphicFrame>
        <p:nvGraphicFramePr>
          <p:cNvPr id="169" name="차트 168">
            <a:extLst>
              <a:ext uri="{FF2B5EF4-FFF2-40B4-BE49-F238E27FC236}">
                <a16:creationId xmlns:a16="http://schemas.microsoft.com/office/drawing/2014/main" id="{B432B271-ADF1-8376-DC45-2B02B76128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4660793"/>
              </p:ext>
            </p:extLst>
          </p:nvPr>
        </p:nvGraphicFramePr>
        <p:xfrm>
          <a:off x="5179959" y="2371460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70" name="TextBox 169">
            <a:extLst>
              <a:ext uri="{FF2B5EF4-FFF2-40B4-BE49-F238E27FC236}">
                <a16:creationId xmlns:a16="http://schemas.microsoft.com/office/drawing/2014/main" id="{9B7EB8ED-433B-5CB3-6B26-23DDC6020677}"/>
              </a:ext>
            </a:extLst>
          </p:cNvPr>
          <p:cNvSpPr txBox="1"/>
          <p:nvPr/>
        </p:nvSpPr>
        <p:spPr>
          <a:xfrm rot="16200000">
            <a:off x="5262728" y="365123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031CAC5B-B0D9-83F2-3D34-239B85B67C91}"/>
              </a:ext>
            </a:extLst>
          </p:cNvPr>
          <p:cNvSpPr txBox="1"/>
          <p:nvPr/>
        </p:nvSpPr>
        <p:spPr>
          <a:xfrm rot="16200000">
            <a:off x="5798594" y="365123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AAF385E5-952C-C87D-2F48-43812403671D}"/>
              </a:ext>
            </a:extLst>
          </p:cNvPr>
          <p:cNvSpPr txBox="1"/>
          <p:nvPr/>
        </p:nvSpPr>
        <p:spPr>
          <a:xfrm rot="16200000">
            <a:off x="5538072" y="364001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D80B1D8C-5E8C-9668-109F-52DF449EF5E5}"/>
              </a:ext>
            </a:extLst>
          </p:cNvPr>
          <p:cNvSpPr txBox="1"/>
          <p:nvPr/>
        </p:nvSpPr>
        <p:spPr>
          <a:xfrm rot="16200000">
            <a:off x="6081558" y="364001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4" name="직선 연결선 173">
            <a:extLst>
              <a:ext uri="{FF2B5EF4-FFF2-40B4-BE49-F238E27FC236}">
                <a16:creationId xmlns:a16="http://schemas.microsoft.com/office/drawing/2014/main" id="{D266ABB3-5FD0-ED64-7156-7150841632A7}"/>
              </a:ext>
            </a:extLst>
          </p:cNvPr>
          <p:cNvCxnSpPr>
            <a:cxnSpLocks/>
          </p:cNvCxnSpPr>
          <p:nvPr/>
        </p:nvCxnSpPr>
        <p:spPr>
          <a:xfrm>
            <a:off x="5458112" y="401719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직선 연결선 174">
            <a:extLst>
              <a:ext uri="{FF2B5EF4-FFF2-40B4-BE49-F238E27FC236}">
                <a16:creationId xmlns:a16="http://schemas.microsoft.com/office/drawing/2014/main" id="{69FA8410-8632-7BF7-EE13-6DE29F3B5AE3}"/>
              </a:ext>
            </a:extLst>
          </p:cNvPr>
          <p:cNvCxnSpPr>
            <a:cxnSpLocks/>
          </p:cNvCxnSpPr>
          <p:nvPr/>
        </p:nvCxnSpPr>
        <p:spPr>
          <a:xfrm>
            <a:off x="6026745" y="401719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Box 175">
            <a:extLst>
              <a:ext uri="{FF2B5EF4-FFF2-40B4-BE49-F238E27FC236}">
                <a16:creationId xmlns:a16="http://schemas.microsoft.com/office/drawing/2014/main" id="{9066E0A1-9EC2-51A9-CC8E-1AC16DC7624E}"/>
              </a:ext>
            </a:extLst>
          </p:cNvPr>
          <p:cNvSpPr txBox="1"/>
          <p:nvPr/>
        </p:nvSpPr>
        <p:spPr>
          <a:xfrm>
            <a:off x="5562500" y="4017198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84DA9D00-4B05-E358-13F7-83D3FE827151}"/>
              </a:ext>
            </a:extLst>
          </p:cNvPr>
          <p:cNvSpPr txBox="1"/>
          <p:nvPr/>
        </p:nvSpPr>
        <p:spPr>
          <a:xfrm>
            <a:off x="6034654" y="4039639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9E075136-D72F-6C98-78E3-7F6059D9C559}"/>
              </a:ext>
            </a:extLst>
          </p:cNvPr>
          <p:cNvSpPr txBox="1"/>
          <p:nvPr/>
        </p:nvSpPr>
        <p:spPr>
          <a:xfrm rot="16200000">
            <a:off x="4661588" y="3013743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3K27me3 / H3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6B2E47E4-EEAB-7A69-4DD2-F532EBEF850E}"/>
              </a:ext>
            </a:extLst>
          </p:cNvPr>
          <p:cNvSpPr txBox="1"/>
          <p:nvPr/>
        </p:nvSpPr>
        <p:spPr>
          <a:xfrm>
            <a:off x="6234003" y="3090872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0" name="차트 179">
            <a:extLst>
              <a:ext uri="{FF2B5EF4-FFF2-40B4-BE49-F238E27FC236}">
                <a16:creationId xmlns:a16="http://schemas.microsoft.com/office/drawing/2014/main" id="{5942C99A-C05C-499C-93EF-4DB46417C7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7780586"/>
              </p:ext>
            </p:extLst>
          </p:nvPr>
        </p:nvGraphicFramePr>
        <p:xfrm>
          <a:off x="358518" y="318608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1" name="TextBox 180">
            <a:extLst>
              <a:ext uri="{FF2B5EF4-FFF2-40B4-BE49-F238E27FC236}">
                <a16:creationId xmlns:a16="http://schemas.microsoft.com/office/drawing/2014/main" id="{F8B0F938-7E99-7522-F62E-75C8D859B8FF}"/>
              </a:ext>
            </a:extLst>
          </p:cNvPr>
          <p:cNvSpPr txBox="1"/>
          <p:nvPr/>
        </p:nvSpPr>
        <p:spPr>
          <a:xfrm>
            <a:off x="1391713" y="1073758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736F8C29-17CB-1191-DC2C-B1F306FF643E}"/>
              </a:ext>
            </a:extLst>
          </p:cNvPr>
          <p:cNvSpPr txBox="1"/>
          <p:nvPr/>
        </p:nvSpPr>
        <p:spPr>
          <a:xfrm>
            <a:off x="4312220" y="961283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0" name="차트 189">
            <a:extLst>
              <a:ext uri="{FF2B5EF4-FFF2-40B4-BE49-F238E27FC236}">
                <a16:creationId xmlns:a16="http://schemas.microsoft.com/office/drawing/2014/main" id="{9E111853-F1BE-4168-9AB5-47772C6978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5358620"/>
              </p:ext>
            </p:extLst>
          </p:nvPr>
        </p:nvGraphicFramePr>
        <p:xfrm>
          <a:off x="1968558" y="318608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1" name="차트 190">
            <a:extLst>
              <a:ext uri="{FF2B5EF4-FFF2-40B4-BE49-F238E27FC236}">
                <a16:creationId xmlns:a16="http://schemas.microsoft.com/office/drawing/2014/main" id="{E4CFCFDA-4710-4E36-9CC9-123DC2CC1F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0750819"/>
              </p:ext>
            </p:extLst>
          </p:nvPr>
        </p:nvGraphicFramePr>
        <p:xfrm>
          <a:off x="3519286" y="306760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2" name="차트 191">
            <a:extLst>
              <a:ext uri="{FF2B5EF4-FFF2-40B4-BE49-F238E27FC236}">
                <a16:creationId xmlns:a16="http://schemas.microsoft.com/office/drawing/2014/main" id="{09BE3467-30A8-4167-A2D5-8F2C2BE08C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4573234"/>
              </p:ext>
            </p:extLst>
          </p:nvPr>
        </p:nvGraphicFramePr>
        <p:xfrm>
          <a:off x="5180390" y="318608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93" name="차트 192">
            <a:extLst>
              <a:ext uri="{FF2B5EF4-FFF2-40B4-BE49-F238E27FC236}">
                <a16:creationId xmlns:a16="http://schemas.microsoft.com/office/drawing/2014/main" id="{A5ECF0A2-9FDF-4548-9B43-F320EF0C79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4004253"/>
              </p:ext>
            </p:extLst>
          </p:nvPr>
        </p:nvGraphicFramePr>
        <p:xfrm>
          <a:off x="358880" y="2389492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94" name="차트 193">
            <a:extLst>
              <a:ext uri="{FF2B5EF4-FFF2-40B4-BE49-F238E27FC236}">
                <a16:creationId xmlns:a16="http://schemas.microsoft.com/office/drawing/2014/main" id="{563CAB40-6639-412C-A7CF-55AA2DA31E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2472887"/>
              </p:ext>
            </p:extLst>
          </p:nvPr>
        </p:nvGraphicFramePr>
        <p:xfrm>
          <a:off x="1954111" y="2389492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95" name="차트 194">
            <a:extLst>
              <a:ext uri="{FF2B5EF4-FFF2-40B4-BE49-F238E27FC236}">
                <a16:creationId xmlns:a16="http://schemas.microsoft.com/office/drawing/2014/main" id="{0C8D255A-9632-46B2-AD33-43C2D1E8F3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9567174"/>
              </p:ext>
            </p:extLst>
          </p:nvPr>
        </p:nvGraphicFramePr>
        <p:xfrm>
          <a:off x="3541150" y="2385200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96" name="TextBox 195">
            <a:extLst>
              <a:ext uri="{FF2B5EF4-FFF2-40B4-BE49-F238E27FC236}">
                <a16:creationId xmlns:a16="http://schemas.microsoft.com/office/drawing/2014/main" id="{AC98FC46-320D-5FF4-7299-8898B3758C80}"/>
              </a:ext>
            </a:extLst>
          </p:cNvPr>
          <p:cNvSpPr txBox="1"/>
          <p:nvPr/>
        </p:nvSpPr>
        <p:spPr>
          <a:xfrm>
            <a:off x="876926" y="3047380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A4D6C07F-0C9F-DED7-A1D5-1874CD021601}"/>
              </a:ext>
            </a:extLst>
          </p:cNvPr>
          <p:cNvSpPr txBox="1"/>
          <p:nvPr/>
        </p:nvSpPr>
        <p:spPr>
          <a:xfrm>
            <a:off x="1411750" y="3110561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A6565878-E177-D5E3-8F3A-F66C63A3F9F2}"/>
              </a:ext>
            </a:extLst>
          </p:cNvPr>
          <p:cNvSpPr txBox="1"/>
          <p:nvPr/>
        </p:nvSpPr>
        <p:spPr>
          <a:xfrm rot="16200000">
            <a:off x="446588" y="574381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61CA36CE-CBB7-B6AD-E1E0-0380A69C0911}"/>
              </a:ext>
            </a:extLst>
          </p:cNvPr>
          <p:cNvSpPr txBox="1"/>
          <p:nvPr/>
        </p:nvSpPr>
        <p:spPr>
          <a:xfrm rot="16200000">
            <a:off x="982454" y="574381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0EBAB998-9A13-1DAB-EFFF-76C9BA80A965}"/>
              </a:ext>
            </a:extLst>
          </p:cNvPr>
          <p:cNvSpPr txBox="1"/>
          <p:nvPr/>
        </p:nvSpPr>
        <p:spPr>
          <a:xfrm rot="16200000">
            <a:off x="721932" y="573259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6165855A-3729-AFEB-A771-2F2366F27261}"/>
              </a:ext>
            </a:extLst>
          </p:cNvPr>
          <p:cNvSpPr txBox="1"/>
          <p:nvPr/>
        </p:nvSpPr>
        <p:spPr>
          <a:xfrm rot="16200000">
            <a:off x="1265418" y="573259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2" name="직선 연결선 201">
            <a:extLst>
              <a:ext uri="{FF2B5EF4-FFF2-40B4-BE49-F238E27FC236}">
                <a16:creationId xmlns:a16="http://schemas.microsoft.com/office/drawing/2014/main" id="{5AB546AE-3FA1-4AA9-DCC0-05A05428A14D}"/>
              </a:ext>
            </a:extLst>
          </p:cNvPr>
          <p:cNvCxnSpPr>
            <a:cxnSpLocks/>
          </p:cNvCxnSpPr>
          <p:nvPr/>
        </p:nvCxnSpPr>
        <p:spPr>
          <a:xfrm>
            <a:off x="641972" y="610977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직선 연결선 202">
            <a:extLst>
              <a:ext uri="{FF2B5EF4-FFF2-40B4-BE49-F238E27FC236}">
                <a16:creationId xmlns:a16="http://schemas.microsoft.com/office/drawing/2014/main" id="{533850A4-9B1F-98B3-29D4-E38141D1923B}"/>
              </a:ext>
            </a:extLst>
          </p:cNvPr>
          <p:cNvCxnSpPr>
            <a:cxnSpLocks/>
          </p:cNvCxnSpPr>
          <p:nvPr/>
        </p:nvCxnSpPr>
        <p:spPr>
          <a:xfrm>
            <a:off x="1210605" y="610977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TextBox 203">
            <a:extLst>
              <a:ext uri="{FF2B5EF4-FFF2-40B4-BE49-F238E27FC236}">
                <a16:creationId xmlns:a16="http://schemas.microsoft.com/office/drawing/2014/main" id="{B105B7EA-A7C6-8DF1-40C0-33403B19967A}"/>
              </a:ext>
            </a:extLst>
          </p:cNvPr>
          <p:cNvSpPr txBox="1"/>
          <p:nvPr/>
        </p:nvSpPr>
        <p:spPr>
          <a:xfrm>
            <a:off x="746360" y="6109778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F93C203E-BE7C-6BED-2DB0-98B1B4C7516D}"/>
              </a:ext>
            </a:extLst>
          </p:cNvPr>
          <p:cNvSpPr txBox="1"/>
          <p:nvPr/>
        </p:nvSpPr>
        <p:spPr>
          <a:xfrm>
            <a:off x="1218514" y="6132219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6F7DC737-4EF3-5E5A-05D9-E3FF24B05BD7}"/>
              </a:ext>
            </a:extLst>
          </p:cNvPr>
          <p:cNvSpPr txBox="1"/>
          <p:nvPr/>
        </p:nvSpPr>
        <p:spPr>
          <a:xfrm rot="16200000">
            <a:off x="-119351" y="5044768"/>
            <a:ext cx="7889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-p38 MAPK</a:t>
            </a:r>
          </a:p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 / p38 MAPK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841C2E2C-5B35-C411-E8A8-F84503F59070}"/>
              </a:ext>
            </a:extLst>
          </p:cNvPr>
          <p:cNvSpPr txBox="1"/>
          <p:nvPr/>
        </p:nvSpPr>
        <p:spPr>
          <a:xfrm rot="16200000">
            <a:off x="2136044" y="574381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9CB50CB7-DE6E-A506-AFB5-BAB8F3FF5819}"/>
              </a:ext>
            </a:extLst>
          </p:cNvPr>
          <p:cNvSpPr txBox="1"/>
          <p:nvPr/>
        </p:nvSpPr>
        <p:spPr>
          <a:xfrm rot="16200000">
            <a:off x="2671910" y="574381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97DA3600-466A-8FC0-29A1-11423C9E94A7}"/>
              </a:ext>
            </a:extLst>
          </p:cNvPr>
          <p:cNvSpPr txBox="1"/>
          <p:nvPr/>
        </p:nvSpPr>
        <p:spPr>
          <a:xfrm rot="16200000">
            <a:off x="2411388" y="573259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3B20EFFB-4287-D744-A923-C6133FBEF0AD}"/>
              </a:ext>
            </a:extLst>
          </p:cNvPr>
          <p:cNvSpPr txBox="1"/>
          <p:nvPr/>
        </p:nvSpPr>
        <p:spPr>
          <a:xfrm rot="16200000">
            <a:off x="2954874" y="573259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1" name="직선 연결선 210">
            <a:extLst>
              <a:ext uri="{FF2B5EF4-FFF2-40B4-BE49-F238E27FC236}">
                <a16:creationId xmlns:a16="http://schemas.microsoft.com/office/drawing/2014/main" id="{F84BD95C-4C7B-E1A1-5D65-1992281E3B26}"/>
              </a:ext>
            </a:extLst>
          </p:cNvPr>
          <p:cNvCxnSpPr>
            <a:cxnSpLocks/>
          </p:cNvCxnSpPr>
          <p:nvPr/>
        </p:nvCxnSpPr>
        <p:spPr>
          <a:xfrm>
            <a:off x="2331428" y="610977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직선 연결선 211">
            <a:extLst>
              <a:ext uri="{FF2B5EF4-FFF2-40B4-BE49-F238E27FC236}">
                <a16:creationId xmlns:a16="http://schemas.microsoft.com/office/drawing/2014/main" id="{32800AFD-181E-8D57-2846-4A85E7D07B99}"/>
              </a:ext>
            </a:extLst>
          </p:cNvPr>
          <p:cNvCxnSpPr>
            <a:cxnSpLocks/>
          </p:cNvCxnSpPr>
          <p:nvPr/>
        </p:nvCxnSpPr>
        <p:spPr>
          <a:xfrm>
            <a:off x="2900061" y="6109778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TextBox 212">
            <a:extLst>
              <a:ext uri="{FF2B5EF4-FFF2-40B4-BE49-F238E27FC236}">
                <a16:creationId xmlns:a16="http://schemas.microsoft.com/office/drawing/2014/main" id="{59E2CBE3-8982-34A2-C466-81A44E95227C}"/>
              </a:ext>
            </a:extLst>
          </p:cNvPr>
          <p:cNvSpPr txBox="1"/>
          <p:nvPr/>
        </p:nvSpPr>
        <p:spPr>
          <a:xfrm>
            <a:off x="2435816" y="6109778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3CF0E8D5-2FDF-FE65-1650-A895FA351409}"/>
              </a:ext>
            </a:extLst>
          </p:cNvPr>
          <p:cNvSpPr txBox="1"/>
          <p:nvPr/>
        </p:nvSpPr>
        <p:spPr>
          <a:xfrm>
            <a:off x="2907970" y="6132219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0797362C-F397-360D-7570-0E11949509AC}"/>
              </a:ext>
            </a:extLst>
          </p:cNvPr>
          <p:cNvSpPr txBox="1"/>
          <p:nvPr/>
        </p:nvSpPr>
        <p:spPr>
          <a:xfrm rot="16200000">
            <a:off x="3828915" y="5747197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103EF9A9-D3DB-B95B-8C68-C7AF32B5C45F}"/>
              </a:ext>
            </a:extLst>
          </p:cNvPr>
          <p:cNvSpPr txBox="1"/>
          <p:nvPr/>
        </p:nvSpPr>
        <p:spPr>
          <a:xfrm rot="16200000">
            <a:off x="4364781" y="5747197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6E756339-E71B-AF28-4573-B08178C3AA35}"/>
              </a:ext>
            </a:extLst>
          </p:cNvPr>
          <p:cNvSpPr txBox="1"/>
          <p:nvPr/>
        </p:nvSpPr>
        <p:spPr>
          <a:xfrm rot="16200000">
            <a:off x="4104259" y="5735976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7900F21E-C277-118F-113D-47BF2F37F036}"/>
              </a:ext>
            </a:extLst>
          </p:cNvPr>
          <p:cNvSpPr txBox="1"/>
          <p:nvPr/>
        </p:nvSpPr>
        <p:spPr>
          <a:xfrm rot="16200000">
            <a:off x="4647745" y="5735976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0" name="직선 연결선 219">
            <a:extLst>
              <a:ext uri="{FF2B5EF4-FFF2-40B4-BE49-F238E27FC236}">
                <a16:creationId xmlns:a16="http://schemas.microsoft.com/office/drawing/2014/main" id="{2865382C-B8F8-936F-663B-7FDA8F3C04C8}"/>
              </a:ext>
            </a:extLst>
          </p:cNvPr>
          <p:cNvCxnSpPr>
            <a:cxnSpLocks/>
          </p:cNvCxnSpPr>
          <p:nvPr/>
        </p:nvCxnSpPr>
        <p:spPr>
          <a:xfrm>
            <a:off x="4024299" y="6113164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직선 연결선 220">
            <a:extLst>
              <a:ext uri="{FF2B5EF4-FFF2-40B4-BE49-F238E27FC236}">
                <a16:creationId xmlns:a16="http://schemas.microsoft.com/office/drawing/2014/main" id="{E03FE59F-7AF8-0A8E-28F3-FE211A2B7A5A}"/>
              </a:ext>
            </a:extLst>
          </p:cNvPr>
          <p:cNvCxnSpPr>
            <a:cxnSpLocks/>
          </p:cNvCxnSpPr>
          <p:nvPr/>
        </p:nvCxnSpPr>
        <p:spPr>
          <a:xfrm>
            <a:off x="4592932" y="6113164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TextBox 221">
            <a:extLst>
              <a:ext uri="{FF2B5EF4-FFF2-40B4-BE49-F238E27FC236}">
                <a16:creationId xmlns:a16="http://schemas.microsoft.com/office/drawing/2014/main" id="{A64F3E33-9590-F20F-C654-7023B0A0CA90}"/>
              </a:ext>
            </a:extLst>
          </p:cNvPr>
          <p:cNvSpPr txBox="1"/>
          <p:nvPr/>
        </p:nvSpPr>
        <p:spPr>
          <a:xfrm>
            <a:off x="4128687" y="61131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4A9D1AB8-2E47-DA81-DD4E-8654EFB189BF}"/>
              </a:ext>
            </a:extLst>
          </p:cNvPr>
          <p:cNvSpPr txBox="1"/>
          <p:nvPr/>
        </p:nvSpPr>
        <p:spPr>
          <a:xfrm>
            <a:off x="4600841" y="6135605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E20DAF5F-C498-40A3-0AE4-F8525427D2A4}"/>
              </a:ext>
            </a:extLst>
          </p:cNvPr>
          <p:cNvSpPr txBox="1"/>
          <p:nvPr/>
        </p:nvSpPr>
        <p:spPr>
          <a:xfrm rot="16200000">
            <a:off x="446588" y="7797728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E2233C6D-345B-AA2E-2B95-B1E7D2D3AF31}"/>
              </a:ext>
            </a:extLst>
          </p:cNvPr>
          <p:cNvSpPr txBox="1"/>
          <p:nvPr/>
        </p:nvSpPr>
        <p:spPr>
          <a:xfrm rot="16200000">
            <a:off x="982454" y="7797728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B1FFEC87-C1E1-A9FD-381B-8903B62CBB19}"/>
              </a:ext>
            </a:extLst>
          </p:cNvPr>
          <p:cNvSpPr txBox="1"/>
          <p:nvPr/>
        </p:nvSpPr>
        <p:spPr>
          <a:xfrm rot="16200000">
            <a:off x="721932" y="7786507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15342EB5-C8AF-2937-71C5-5BC84EED47AE}"/>
              </a:ext>
            </a:extLst>
          </p:cNvPr>
          <p:cNvSpPr txBox="1"/>
          <p:nvPr/>
        </p:nvSpPr>
        <p:spPr>
          <a:xfrm rot="16200000">
            <a:off x="1265418" y="7786507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9" name="직선 연결선 228">
            <a:extLst>
              <a:ext uri="{FF2B5EF4-FFF2-40B4-BE49-F238E27FC236}">
                <a16:creationId xmlns:a16="http://schemas.microsoft.com/office/drawing/2014/main" id="{19AF69C7-BEAE-002E-F6AC-6F327EC8264B}"/>
              </a:ext>
            </a:extLst>
          </p:cNvPr>
          <p:cNvCxnSpPr>
            <a:cxnSpLocks/>
          </p:cNvCxnSpPr>
          <p:nvPr/>
        </p:nvCxnSpPr>
        <p:spPr>
          <a:xfrm>
            <a:off x="641972" y="8163695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직선 연결선 229">
            <a:extLst>
              <a:ext uri="{FF2B5EF4-FFF2-40B4-BE49-F238E27FC236}">
                <a16:creationId xmlns:a16="http://schemas.microsoft.com/office/drawing/2014/main" id="{3BCF3293-990E-E3EB-9B78-DE71EA661AAD}"/>
              </a:ext>
            </a:extLst>
          </p:cNvPr>
          <p:cNvCxnSpPr>
            <a:cxnSpLocks/>
          </p:cNvCxnSpPr>
          <p:nvPr/>
        </p:nvCxnSpPr>
        <p:spPr>
          <a:xfrm>
            <a:off x="1210605" y="8163695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1" name="TextBox 230">
            <a:extLst>
              <a:ext uri="{FF2B5EF4-FFF2-40B4-BE49-F238E27FC236}">
                <a16:creationId xmlns:a16="http://schemas.microsoft.com/office/drawing/2014/main" id="{F4187CE7-63F9-100D-739C-50795E402336}"/>
              </a:ext>
            </a:extLst>
          </p:cNvPr>
          <p:cNvSpPr txBox="1"/>
          <p:nvPr/>
        </p:nvSpPr>
        <p:spPr>
          <a:xfrm>
            <a:off x="746360" y="8163695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80FD4385-8B8A-A800-B1CB-8A141FB19396}"/>
              </a:ext>
            </a:extLst>
          </p:cNvPr>
          <p:cNvSpPr txBox="1"/>
          <p:nvPr/>
        </p:nvSpPr>
        <p:spPr>
          <a:xfrm>
            <a:off x="1218514" y="8186136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42F96EB0-380D-6AE8-45A6-30C75E774A98}"/>
              </a:ext>
            </a:extLst>
          </p:cNvPr>
          <p:cNvSpPr txBox="1"/>
          <p:nvPr/>
        </p:nvSpPr>
        <p:spPr>
          <a:xfrm rot="16200000">
            <a:off x="2136044" y="7797728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71628A3F-CB3A-4AAA-E535-015CDEAE0850}"/>
              </a:ext>
            </a:extLst>
          </p:cNvPr>
          <p:cNvSpPr txBox="1"/>
          <p:nvPr/>
        </p:nvSpPr>
        <p:spPr>
          <a:xfrm rot="16200000">
            <a:off x="2671910" y="7797728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W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D964CB8E-935F-06AD-2318-22D113D885C6}"/>
              </a:ext>
            </a:extLst>
          </p:cNvPr>
          <p:cNvSpPr txBox="1"/>
          <p:nvPr/>
        </p:nvSpPr>
        <p:spPr>
          <a:xfrm rot="16200000">
            <a:off x="2411388" y="7786507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71E16817-9F10-F5BB-E4C1-CE8F2F385320}"/>
              </a:ext>
            </a:extLst>
          </p:cNvPr>
          <p:cNvSpPr txBox="1"/>
          <p:nvPr/>
        </p:nvSpPr>
        <p:spPr>
          <a:xfrm rot="16200000">
            <a:off x="2954874" y="7786507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549-R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8" name="직선 연결선 237">
            <a:extLst>
              <a:ext uri="{FF2B5EF4-FFF2-40B4-BE49-F238E27FC236}">
                <a16:creationId xmlns:a16="http://schemas.microsoft.com/office/drawing/2014/main" id="{2D2CABBA-EA20-3D7E-5EE7-FA4A550BC075}"/>
              </a:ext>
            </a:extLst>
          </p:cNvPr>
          <p:cNvCxnSpPr>
            <a:cxnSpLocks/>
          </p:cNvCxnSpPr>
          <p:nvPr/>
        </p:nvCxnSpPr>
        <p:spPr>
          <a:xfrm>
            <a:off x="2331428" y="8163695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직선 연결선 238">
            <a:extLst>
              <a:ext uri="{FF2B5EF4-FFF2-40B4-BE49-F238E27FC236}">
                <a16:creationId xmlns:a16="http://schemas.microsoft.com/office/drawing/2014/main" id="{7C5EB9FE-CD55-BE11-0DD2-8AC1D6C02571}"/>
              </a:ext>
            </a:extLst>
          </p:cNvPr>
          <p:cNvCxnSpPr>
            <a:cxnSpLocks/>
          </p:cNvCxnSpPr>
          <p:nvPr/>
        </p:nvCxnSpPr>
        <p:spPr>
          <a:xfrm>
            <a:off x="2900061" y="8163695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TextBox 239">
            <a:extLst>
              <a:ext uri="{FF2B5EF4-FFF2-40B4-BE49-F238E27FC236}">
                <a16:creationId xmlns:a16="http://schemas.microsoft.com/office/drawing/2014/main" id="{91E9C084-7418-1F36-8F4A-B3C7F819F19E}"/>
              </a:ext>
            </a:extLst>
          </p:cNvPr>
          <p:cNvSpPr txBox="1"/>
          <p:nvPr/>
        </p:nvSpPr>
        <p:spPr>
          <a:xfrm>
            <a:off x="2435816" y="8163695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5ED3220E-6D51-21F2-0D84-4C33ADD85122}"/>
              </a:ext>
            </a:extLst>
          </p:cNvPr>
          <p:cNvSpPr txBox="1"/>
          <p:nvPr/>
        </p:nvSpPr>
        <p:spPr>
          <a:xfrm>
            <a:off x="2907970" y="8186136"/>
            <a:ext cx="3609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e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E6300F93-AA25-6A80-FB42-40B35BC6FCE6}"/>
              </a:ext>
            </a:extLst>
          </p:cNvPr>
          <p:cNvSpPr txBox="1"/>
          <p:nvPr/>
        </p:nvSpPr>
        <p:spPr>
          <a:xfrm>
            <a:off x="834996" y="4720989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E11DAC6D-7B52-5987-79EF-393B582913AE}"/>
              </a:ext>
            </a:extLst>
          </p:cNvPr>
          <p:cNvSpPr txBox="1"/>
          <p:nvPr/>
        </p:nvSpPr>
        <p:spPr>
          <a:xfrm>
            <a:off x="2551367" y="5230775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2" name="차트 261">
            <a:extLst>
              <a:ext uri="{FF2B5EF4-FFF2-40B4-BE49-F238E27FC236}">
                <a16:creationId xmlns:a16="http://schemas.microsoft.com/office/drawing/2014/main" id="{5942C99A-C05C-499C-93EF-4DB46417C7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1258124"/>
              </p:ext>
            </p:extLst>
          </p:nvPr>
        </p:nvGraphicFramePr>
        <p:xfrm>
          <a:off x="348274" y="4474653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63" name="차트 262">
            <a:extLst>
              <a:ext uri="{FF2B5EF4-FFF2-40B4-BE49-F238E27FC236}">
                <a16:creationId xmlns:a16="http://schemas.microsoft.com/office/drawing/2014/main" id="{15965118-D088-4AA0-9F5F-0CEB6B4AB5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6732372"/>
              </p:ext>
            </p:extLst>
          </p:nvPr>
        </p:nvGraphicFramePr>
        <p:xfrm>
          <a:off x="2061000" y="4474209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64" name="차트 263">
            <a:extLst>
              <a:ext uri="{FF2B5EF4-FFF2-40B4-BE49-F238E27FC236}">
                <a16:creationId xmlns:a16="http://schemas.microsoft.com/office/drawing/2014/main" id="{6BE17D6E-F6AD-40F4-8AF2-8E347F8D33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4486552"/>
              </p:ext>
            </p:extLst>
          </p:nvPr>
        </p:nvGraphicFramePr>
        <p:xfrm>
          <a:off x="358518" y="6536964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65" name="차트 264">
            <a:extLst>
              <a:ext uri="{FF2B5EF4-FFF2-40B4-BE49-F238E27FC236}">
                <a16:creationId xmlns:a16="http://schemas.microsoft.com/office/drawing/2014/main" id="{7B0E2E9E-3535-4334-98CF-7479B090FB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9604290"/>
              </p:ext>
            </p:extLst>
          </p:nvPr>
        </p:nvGraphicFramePr>
        <p:xfrm>
          <a:off x="2058897" y="6536964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266" name="TextBox 265">
            <a:extLst>
              <a:ext uri="{FF2B5EF4-FFF2-40B4-BE49-F238E27FC236}">
                <a16:creationId xmlns:a16="http://schemas.microsoft.com/office/drawing/2014/main" id="{872145A1-8F3E-F8AD-C9F3-BEE5BC619E30}"/>
              </a:ext>
            </a:extLst>
          </p:cNvPr>
          <p:cNvSpPr txBox="1"/>
          <p:nvPr/>
        </p:nvSpPr>
        <p:spPr>
          <a:xfrm rot="16200000">
            <a:off x="1618029" y="5123407"/>
            <a:ext cx="7232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-p65 / p65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5BEED25B-F8CD-2C30-5EF0-58FF6A4CEF18}"/>
              </a:ext>
            </a:extLst>
          </p:cNvPr>
          <p:cNvSpPr txBox="1"/>
          <p:nvPr/>
        </p:nvSpPr>
        <p:spPr>
          <a:xfrm rot="16200000">
            <a:off x="-240493" y="7175217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-STAT3 / STAT3</a:t>
            </a:r>
          </a:p>
        </p:txBody>
      </p:sp>
      <p:graphicFrame>
        <p:nvGraphicFramePr>
          <p:cNvPr id="269" name="차트 268">
            <a:extLst>
              <a:ext uri="{FF2B5EF4-FFF2-40B4-BE49-F238E27FC236}">
                <a16:creationId xmlns:a16="http://schemas.microsoft.com/office/drawing/2014/main" id="{D108E45D-3702-49F2-8483-E06D65CE98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4164272"/>
              </p:ext>
            </p:extLst>
          </p:nvPr>
        </p:nvGraphicFramePr>
        <p:xfrm>
          <a:off x="3761446" y="4474527"/>
          <a:ext cx="144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270" name="TextBox 269">
            <a:extLst>
              <a:ext uri="{FF2B5EF4-FFF2-40B4-BE49-F238E27FC236}">
                <a16:creationId xmlns:a16="http://schemas.microsoft.com/office/drawing/2014/main" id="{B9EF363C-0DB0-9889-89D8-89DAD30968DC}"/>
              </a:ext>
            </a:extLst>
          </p:cNvPr>
          <p:cNvSpPr txBox="1"/>
          <p:nvPr/>
        </p:nvSpPr>
        <p:spPr>
          <a:xfrm rot="16200000">
            <a:off x="3169897" y="5124147"/>
            <a:ext cx="9829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-mTOR / mTOR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880BD6D1-155C-1BE3-F719-D0103E8A8F89}"/>
              </a:ext>
            </a:extLst>
          </p:cNvPr>
          <p:cNvSpPr txBox="1"/>
          <p:nvPr/>
        </p:nvSpPr>
        <p:spPr>
          <a:xfrm rot="16200000">
            <a:off x="1461057" y="7192211"/>
            <a:ext cx="10182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-STAT5 / STAT5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804152AD-0984-F41B-CC8E-6C0F832538B7}"/>
              </a:ext>
            </a:extLst>
          </p:cNvPr>
          <p:cNvSpPr txBox="1"/>
          <p:nvPr/>
        </p:nvSpPr>
        <p:spPr>
          <a:xfrm>
            <a:off x="3097309" y="5209554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5D7A961-8800-F204-B8CB-158906C07EDC}"/>
              </a:ext>
            </a:extLst>
          </p:cNvPr>
          <p:cNvSpPr txBox="1"/>
          <p:nvPr/>
        </p:nvSpPr>
        <p:spPr>
          <a:xfrm>
            <a:off x="-12700" y="8663011"/>
            <a:ext cx="68707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9. </a:t>
            </a:r>
            <a:r>
              <a:rPr lang="en-US" altLang="ko-KR" sz="1200" b="1" i="0" u="none" strike="noStrike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lterations </a:t>
            </a:r>
            <a:r>
              <a:rPr lang="en-US" altLang="ko-KR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f epigenetic histone marks and signaling pathways in A549-R cells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690643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94</TotalTime>
  <Words>412</Words>
  <Application>Microsoft Office PowerPoint</Application>
  <PresentationFormat>Letter 용지(8.5x11in)</PresentationFormat>
  <Paragraphs>175</Paragraphs>
  <Slides>10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7" baseType="lpstr">
      <vt:lpstr>굴림</vt:lpstr>
      <vt:lpstr>맑은 고딕</vt:lpstr>
      <vt:lpstr>Arial</vt:lpstr>
      <vt:lpstr>Calibri</vt:lpstr>
      <vt:lpstr>Calibri Light</vt:lpstr>
      <vt:lpstr>Office 테마</vt:lpstr>
      <vt:lpstr>Prism Project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서동수</dc:creator>
  <cp:lastModifiedBy>FOR</cp:lastModifiedBy>
  <cp:revision>55</cp:revision>
  <cp:lastPrinted>2023-04-24T07:53:37Z</cp:lastPrinted>
  <dcterms:created xsi:type="dcterms:W3CDTF">2022-12-05T06:49:26Z</dcterms:created>
  <dcterms:modified xsi:type="dcterms:W3CDTF">2023-04-24T08:43:10Z</dcterms:modified>
</cp:coreProperties>
</file>